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sldIdLst>
    <p:sldId id="256" r:id="rId2"/>
  </p:sldIdLst>
  <p:sldSz cx="9753600" cy="7315200"/>
  <p:notesSz cx="6858000" cy="9144000"/>
  <p:embeddedFontLst>
    <p:embeddedFont>
      <p:font typeface="Canva Sans" panose="020B0604020202020204" charset="0"/>
      <p:regular r:id="rId3"/>
    </p:embeddedFont>
    <p:embeddedFont>
      <p:font typeface="Canva Sans Bold" panose="020B0604020202020204" charset="0"/>
      <p:regular r:id="rId4"/>
      <p:bold r:id="rId5"/>
    </p:embeddedFont>
    <p:embeddedFont>
      <p:font typeface="Times New Roman Bold" panose="02020803070505020304" pitchFamily="18" charset="0"/>
      <p:regular r:id="rId6"/>
      <p:bold r:id="rId7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8" autoAdjust="0"/>
    <p:restoredTop sz="94614" autoAdjust="0"/>
  </p:normalViewPr>
  <p:slideViewPr>
    <p:cSldViewPr>
      <p:cViewPr varScale="1">
        <p:scale>
          <a:sx n="82" d="100"/>
          <a:sy n="82" d="100"/>
        </p:scale>
        <p:origin x="1181" y="6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font" Target="fonts/font1.fntdata"/><Relationship Id="rId7" Type="http://schemas.openxmlformats.org/officeDocument/2006/relationships/font" Target="fonts/font5.fnt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4.fntdata"/><Relationship Id="rId11" Type="http://schemas.openxmlformats.org/officeDocument/2006/relationships/tableStyles" Target="tableStyles.xml"/><Relationship Id="rId5" Type="http://schemas.openxmlformats.org/officeDocument/2006/relationships/font" Target="fonts/font3.fntdata"/><Relationship Id="rId10" Type="http://schemas.openxmlformats.org/officeDocument/2006/relationships/theme" Target="theme/theme1.xml"/><Relationship Id="rId4" Type="http://schemas.openxmlformats.org/officeDocument/2006/relationships/font" Target="fonts/font2.fntdata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595959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reeform 2"/>
          <p:cNvSpPr/>
          <p:nvPr/>
        </p:nvSpPr>
        <p:spPr>
          <a:xfrm>
            <a:off x="0" y="1637846"/>
            <a:ext cx="9753600" cy="4810240"/>
          </a:xfrm>
          <a:custGeom>
            <a:avLst/>
            <a:gdLst/>
            <a:ahLst/>
            <a:cxnLst/>
            <a:rect l="l" t="t" r="r" b="b"/>
            <a:pathLst>
              <a:path w="9753600" h="4810240">
                <a:moveTo>
                  <a:pt x="0" y="0"/>
                </a:moveTo>
                <a:lnTo>
                  <a:pt x="9753600" y="0"/>
                </a:lnTo>
                <a:lnTo>
                  <a:pt x="9753600" y="4810240"/>
                </a:lnTo>
                <a:lnTo>
                  <a:pt x="0" y="4810240"/>
                </a:lnTo>
                <a:lnTo>
                  <a:pt x="0" y="0"/>
                </a:lnTo>
                <a:close/>
              </a:path>
            </a:pathLst>
          </a:custGeom>
          <a:blipFill>
            <a:blip r:embed="rId2"/>
            <a:stretch>
              <a:fillRect r="-3441" b="-4960"/>
            </a:stretch>
          </a:blipFill>
        </p:spPr>
        <p:txBody>
          <a:bodyPr/>
          <a:lstStyle/>
          <a:p>
            <a:endParaRPr lang="en-US"/>
          </a:p>
        </p:txBody>
      </p:sp>
      <p:grpSp>
        <p:nvGrpSpPr>
          <p:cNvPr id="3" name="Group 3"/>
          <p:cNvGrpSpPr/>
          <p:nvPr/>
        </p:nvGrpSpPr>
        <p:grpSpPr>
          <a:xfrm>
            <a:off x="6660618" y="1398196"/>
            <a:ext cx="957362" cy="249552"/>
            <a:chOff x="0" y="0"/>
            <a:chExt cx="354579" cy="92427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354579" cy="92427"/>
            </a:xfrm>
            <a:custGeom>
              <a:avLst/>
              <a:gdLst/>
              <a:ahLst/>
              <a:cxnLst/>
              <a:rect l="l" t="t" r="r" b="b"/>
              <a:pathLst>
                <a:path w="354579" h="92427">
                  <a:moveTo>
                    <a:pt x="46213" y="0"/>
                  </a:moveTo>
                  <a:lnTo>
                    <a:pt x="308365" y="0"/>
                  </a:lnTo>
                  <a:cubicBezTo>
                    <a:pt x="333888" y="0"/>
                    <a:pt x="354579" y="20690"/>
                    <a:pt x="354579" y="46213"/>
                  </a:cubicBezTo>
                  <a:lnTo>
                    <a:pt x="354579" y="46213"/>
                  </a:lnTo>
                  <a:cubicBezTo>
                    <a:pt x="354579" y="58470"/>
                    <a:pt x="349710" y="70224"/>
                    <a:pt x="341043" y="78891"/>
                  </a:cubicBezTo>
                  <a:cubicBezTo>
                    <a:pt x="332376" y="87558"/>
                    <a:pt x="320622" y="92427"/>
                    <a:pt x="308365" y="92427"/>
                  </a:cubicBezTo>
                  <a:lnTo>
                    <a:pt x="46213" y="92427"/>
                  </a:lnTo>
                  <a:cubicBezTo>
                    <a:pt x="33957" y="92427"/>
                    <a:pt x="22202" y="87558"/>
                    <a:pt x="13536" y="78891"/>
                  </a:cubicBezTo>
                  <a:cubicBezTo>
                    <a:pt x="4869" y="70224"/>
                    <a:pt x="0" y="58470"/>
                    <a:pt x="0" y="46213"/>
                  </a:cubicBezTo>
                  <a:lnTo>
                    <a:pt x="0" y="46213"/>
                  </a:lnTo>
                  <a:cubicBezTo>
                    <a:pt x="0" y="33957"/>
                    <a:pt x="4869" y="22202"/>
                    <a:pt x="13536" y="13536"/>
                  </a:cubicBezTo>
                  <a:cubicBezTo>
                    <a:pt x="22202" y="4869"/>
                    <a:pt x="33957" y="0"/>
                    <a:pt x="46213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5" name="TextBox 5"/>
            <p:cNvSpPr txBox="1"/>
            <p:nvPr/>
          </p:nvSpPr>
          <p:spPr>
            <a:xfrm>
              <a:off x="0" y="-28575"/>
              <a:ext cx="354579" cy="121002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260"/>
                </a:lnSpc>
              </a:pPr>
              <a:r>
                <a:rPr lang="en-US" sz="900" b="1">
                  <a:solidFill>
                    <a:srgbClr val="000000"/>
                  </a:solidFill>
                  <a:latin typeface="Times New Roman Bold"/>
                  <a:ea typeface="Times New Roman Bold"/>
                  <a:cs typeface="Times New Roman Bold"/>
                  <a:sym typeface="Times New Roman Bold"/>
                </a:rPr>
                <a:t>PROVINCES</a:t>
              </a:r>
            </a:p>
          </p:txBody>
        </p:sp>
      </p:grpSp>
      <p:grpSp>
        <p:nvGrpSpPr>
          <p:cNvPr id="6" name="Group 6"/>
          <p:cNvGrpSpPr/>
          <p:nvPr/>
        </p:nvGrpSpPr>
        <p:grpSpPr>
          <a:xfrm>
            <a:off x="7637031" y="1398196"/>
            <a:ext cx="948412" cy="249552"/>
            <a:chOff x="0" y="0"/>
            <a:chExt cx="351264" cy="92427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351264" cy="92427"/>
            </a:xfrm>
            <a:custGeom>
              <a:avLst/>
              <a:gdLst/>
              <a:ahLst/>
              <a:cxnLst/>
              <a:rect l="l" t="t" r="r" b="b"/>
              <a:pathLst>
                <a:path w="351264" h="92427">
                  <a:moveTo>
                    <a:pt x="46213" y="0"/>
                  </a:moveTo>
                  <a:lnTo>
                    <a:pt x="305050" y="0"/>
                  </a:lnTo>
                  <a:cubicBezTo>
                    <a:pt x="330573" y="0"/>
                    <a:pt x="351264" y="20690"/>
                    <a:pt x="351264" y="46213"/>
                  </a:cubicBezTo>
                  <a:lnTo>
                    <a:pt x="351264" y="46213"/>
                  </a:lnTo>
                  <a:cubicBezTo>
                    <a:pt x="351264" y="58470"/>
                    <a:pt x="346395" y="70224"/>
                    <a:pt x="337728" y="78891"/>
                  </a:cubicBezTo>
                  <a:cubicBezTo>
                    <a:pt x="329061" y="87558"/>
                    <a:pt x="317307" y="92427"/>
                    <a:pt x="305050" y="92427"/>
                  </a:cubicBezTo>
                  <a:lnTo>
                    <a:pt x="46213" y="92427"/>
                  </a:lnTo>
                  <a:cubicBezTo>
                    <a:pt x="33957" y="92427"/>
                    <a:pt x="22202" y="87558"/>
                    <a:pt x="13536" y="78891"/>
                  </a:cubicBezTo>
                  <a:cubicBezTo>
                    <a:pt x="4869" y="70224"/>
                    <a:pt x="0" y="58470"/>
                    <a:pt x="0" y="46213"/>
                  </a:cubicBezTo>
                  <a:lnTo>
                    <a:pt x="0" y="46213"/>
                  </a:lnTo>
                  <a:cubicBezTo>
                    <a:pt x="0" y="33957"/>
                    <a:pt x="4869" y="22202"/>
                    <a:pt x="13536" y="13536"/>
                  </a:cubicBezTo>
                  <a:cubicBezTo>
                    <a:pt x="22202" y="4869"/>
                    <a:pt x="33957" y="0"/>
                    <a:pt x="46213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8" name="TextBox 8"/>
            <p:cNvSpPr txBox="1"/>
            <p:nvPr/>
          </p:nvSpPr>
          <p:spPr>
            <a:xfrm>
              <a:off x="0" y="-28575"/>
              <a:ext cx="351264" cy="121002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260"/>
                </a:lnSpc>
              </a:pPr>
              <a:r>
                <a:rPr lang="en-US" sz="900" b="1">
                  <a:solidFill>
                    <a:srgbClr val="000000"/>
                  </a:solidFill>
                  <a:latin typeface="Times New Roman Bold"/>
                  <a:ea typeface="Times New Roman Bold"/>
                  <a:cs typeface="Times New Roman Bold"/>
                  <a:sym typeface="Times New Roman Bold"/>
                </a:rPr>
                <a:t>DISTRICTS</a:t>
              </a:r>
            </a:p>
          </p:txBody>
        </p:sp>
      </p:grpSp>
      <p:grpSp>
        <p:nvGrpSpPr>
          <p:cNvPr id="9" name="Group 9"/>
          <p:cNvGrpSpPr/>
          <p:nvPr/>
        </p:nvGrpSpPr>
        <p:grpSpPr>
          <a:xfrm>
            <a:off x="5594651" y="1398196"/>
            <a:ext cx="1046917" cy="249552"/>
            <a:chOff x="0" y="0"/>
            <a:chExt cx="387747" cy="92427"/>
          </a:xfrm>
        </p:grpSpPr>
        <p:sp>
          <p:nvSpPr>
            <p:cNvPr id="10" name="Freeform 10"/>
            <p:cNvSpPr/>
            <p:nvPr/>
          </p:nvSpPr>
          <p:spPr>
            <a:xfrm>
              <a:off x="0" y="0"/>
              <a:ext cx="387747" cy="92427"/>
            </a:xfrm>
            <a:custGeom>
              <a:avLst/>
              <a:gdLst/>
              <a:ahLst/>
              <a:cxnLst/>
              <a:rect l="l" t="t" r="r" b="b"/>
              <a:pathLst>
                <a:path w="387747" h="92427">
                  <a:moveTo>
                    <a:pt x="46213" y="0"/>
                  </a:moveTo>
                  <a:lnTo>
                    <a:pt x="341534" y="0"/>
                  </a:lnTo>
                  <a:cubicBezTo>
                    <a:pt x="353790" y="0"/>
                    <a:pt x="365545" y="4869"/>
                    <a:pt x="374212" y="13536"/>
                  </a:cubicBezTo>
                  <a:cubicBezTo>
                    <a:pt x="382878" y="22202"/>
                    <a:pt x="387747" y="33957"/>
                    <a:pt x="387747" y="46213"/>
                  </a:cubicBezTo>
                  <a:lnTo>
                    <a:pt x="387747" y="46213"/>
                  </a:lnTo>
                  <a:cubicBezTo>
                    <a:pt x="387747" y="58470"/>
                    <a:pt x="382878" y="70224"/>
                    <a:pt x="374212" y="78891"/>
                  </a:cubicBezTo>
                  <a:cubicBezTo>
                    <a:pt x="365545" y="87558"/>
                    <a:pt x="353790" y="92427"/>
                    <a:pt x="341534" y="92427"/>
                  </a:cubicBezTo>
                  <a:lnTo>
                    <a:pt x="46213" y="92427"/>
                  </a:lnTo>
                  <a:cubicBezTo>
                    <a:pt x="33957" y="92427"/>
                    <a:pt x="22202" y="87558"/>
                    <a:pt x="13536" y="78891"/>
                  </a:cubicBezTo>
                  <a:cubicBezTo>
                    <a:pt x="4869" y="70224"/>
                    <a:pt x="0" y="58470"/>
                    <a:pt x="0" y="46213"/>
                  </a:cubicBezTo>
                  <a:lnTo>
                    <a:pt x="0" y="46213"/>
                  </a:lnTo>
                  <a:cubicBezTo>
                    <a:pt x="0" y="33957"/>
                    <a:pt x="4869" y="22202"/>
                    <a:pt x="13536" y="13536"/>
                  </a:cubicBezTo>
                  <a:cubicBezTo>
                    <a:pt x="22202" y="4869"/>
                    <a:pt x="33957" y="0"/>
                    <a:pt x="46213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1" name="TextBox 11"/>
            <p:cNvSpPr txBox="1"/>
            <p:nvPr/>
          </p:nvSpPr>
          <p:spPr>
            <a:xfrm>
              <a:off x="0" y="-28575"/>
              <a:ext cx="387747" cy="121002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260"/>
                </a:lnSpc>
              </a:pPr>
              <a:r>
                <a:rPr lang="en-US" sz="900" b="1">
                  <a:solidFill>
                    <a:srgbClr val="000000"/>
                  </a:solidFill>
                  <a:latin typeface="Times New Roman Bold"/>
                  <a:ea typeface="Times New Roman Bold"/>
                  <a:cs typeface="Times New Roman Bold"/>
                  <a:sym typeface="Times New Roman Bold"/>
                </a:rPr>
                <a:t>SCHOOLS</a:t>
              </a:r>
            </a:p>
          </p:txBody>
        </p:sp>
      </p:grpSp>
      <p:grpSp>
        <p:nvGrpSpPr>
          <p:cNvPr id="12" name="Group 12"/>
          <p:cNvGrpSpPr/>
          <p:nvPr/>
        </p:nvGrpSpPr>
        <p:grpSpPr>
          <a:xfrm>
            <a:off x="3044789" y="1404807"/>
            <a:ext cx="652019" cy="249552"/>
            <a:chOff x="0" y="0"/>
            <a:chExt cx="241488" cy="92427"/>
          </a:xfrm>
        </p:grpSpPr>
        <p:sp>
          <p:nvSpPr>
            <p:cNvPr id="13" name="Freeform 13"/>
            <p:cNvSpPr/>
            <p:nvPr/>
          </p:nvSpPr>
          <p:spPr>
            <a:xfrm>
              <a:off x="0" y="0"/>
              <a:ext cx="241488" cy="92427"/>
            </a:xfrm>
            <a:custGeom>
              <a:avLst/>
              <a:gdLst/>
              <a:ahLst/>
              <a:cxnLst/>
              <a:rect l="l" t="t" r="r" b="b"/>
              <a:pathLst>
                <a:path w="241488" h="92427">
                  <a:moveTo>
                    <a:pt x="46213" y="0"/>
                  </a:moveTo>
                  <a:lnTo>
                    <a:pt x="195275" y="0"/>
                  </a:lnTo>
                  <a:cubicBezTo>
                    <a:pt x="207532" y="0"/>
                    <a:pt x="219286" y="4869"/>
                    <a:pt x="227953" y="13536"/>
                  </a:cubicBezTo>
                  <a:cubicBezTo>
                    <a:pt x="236620" y="22202"/>
                    <a:pt x="241488" y="33957"/>
                    <a:pt x="241488" y="46213"/>
                  </a:cubicBezTo>
                  <a:lnTo>
                    <a:pt x="241488" y="46213"/>
                  </a:lnTo>
                  <a:cubicBezTo>
                    <a:pt x="241488" y="71736"/>
                    <a:pt x="220798" y="92427"/>
                    <a:pt x="195275" y="92427"/>
                  </a:cubicBezTo>
                  <a:lnTo>
                    <a:pt x="46213" y="92427"/>
                  </a:lnTo>
                  <a:cubicBezTo>
                    <a:pt x="33957" y="92427"/>
                    <a:pt x="22202" y="87558"/>
                    <a:pt x="13536" y="78891"/>
                  </a:cubicBezTo>
                  <a:cubicBezTo>
                    <a:pt x="4869" y="70224"/>
                    <a:pt x="0" y="58470"/>
                    <a:pt x="0" y="46213"/>
                  </a:cubicBezTo>
                  <a:lnTo>
                    <a:pt x="0" y="46213"/>
                  </a:lnTo>
                  <a:cubicBezTo>
                    <a:pt x="0" y="33957"/>
                    <a:pt x="4869" y="22202"/>
                    <a:pt x="13536" y="13536"/>
                  </a:cubicBezTo>
                  <a:cubicBezTo>
                    <a:pt x="22202" y="4869"/>
                    <a:pt x="33957" y="0"/>
                    <a:pt x="46213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4" name="TextBox 14"/>
            <p:cNvSpPr txBox="1"/>
            <p:nvPr/>
          </p:nvSpPr>
          <p:spPr>
            <a:xfrm>
              <a:off x="0" y="-28575"/>
              <a:ext cx="241488" cy="121002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260"/>
                </a:lnSpc>
              </a:pPr>
              <a:r>
                <a:rPr lang="en-US" sz="900" b="1">
                  <a:solidFill>
                    <a:srgbClr val="000000"/>
                  </a:solidFill>
                  <a:latin typeface="Times New Roman Bold"/>
                  <a:ea typeface="Times New Roman Bold"/>
                  <a:cs typeface="Times New Roman Bold"/>
                  <a:sym typeface="Times New Roman Bold"/>
                </a:rPr>
                <a:t>DEATHS</a:t>
              </a:r>
            </a:p>
          </p:txBody>
        </p:sp>
      </p:grpSp>
      <p:grpSp>
        <p:nvGrpSpPr>
          <p:cNvPr id="15" name="Group 15"/>
          <p:cNvGrpSpPr/>
          <p:nvPr/>
        </p:nvGrpSpPr>
        <p:grpSpPr>
          <a:xfrm>
            <a:off x="2162706" y="1407405"/>
            <a:ext cx="853508" cy="249552"/>
            <a:chOff x="0" y="0"/>
            <a:chExt cx="316114" cy="92427"/>
          </a:xfrm>
        </p:grpSpPr>
        <p:sp>
          <p:nvSpPr>
            <p:cNvPr id="16" name="Freeform 16"/>
            <p:cNvSpPr/>
            <p:nvPr/>
          </p:nvSpPr>
          <p:spPr>
            <a:xfrm>
              <a:off x="0" y="0"/>
              <a:ext cx="316114" cy="92427"/>
            </a:xfrm>
            <a:custGeom>
              <a:avLst/>
              <a:gdLst/>
              <a:ahLst/>
              <a:cxnLst/>
              <a:rect l="l" t="t" r="r" b="b"/>
              <a:pathLst>
                <a:path w="316114" h="92427">
                  <a:moveTo>
                    <a:pt x="46213" y="0"/>
                  </a:moveTo>
                  <a:lnTo>
                    <a:pt x="269901" y="0"/>
                  </a:lnTo>
                  <a:cubicBezTo>
                    <a:pt x="295424" y="0"/>
                    <a:pt x="316114" y="20690"/>
                    <a:pt x="316114" y="46213"/>
                  </a:cubicBezTo>
                  <a:lnTo>
                    <a:pt x="316114" y="46213"/>
                  </a:lnTo>
                  <a:cubicBezTo>
                    <a:pt x="316114" y="58470"/>
                    <a:pt x="311245" y="70224"/>
                    <a:pt x="302578" y="78891"/>
                  </a:cubicBezTo>
                  <a:cubicBezTo>
                    <a:pt x="293912" y="87558"/>
                    <a:pt x="282157" y="92427"/>
                    <a:pt x="269901" y="92427"/>
                  </a:cubicBezTo>
                  <a:lnTo>
                    <a:pt x="46213" y="92427"/>
                  </a:lnTo>
                  <a:cubicBezTo>
                    <a:pt x="33957" y="92427"/>
                    <a:pt x="22202" y="87558"/>
                    <a:pt x="13536" y="78891"/>
                  </a:cubicBezTo>
                  <a:cubicBezTo>
                    <a:pt x="4869" y="70224"/>
                    <a:pt x="0" y="58470"/>
                    <a:pt x="0" y="46213"/>
                  </a:cubicBezTo>
                  <a:lnTo>
                    <a:pt x="0" y="46213"/>
                  </a:lnTo>
                  <a:cubicBezTo>
                    <a:pt x="0" y="33957"/>
                    <a:pt x="4869" y="22202"/>
                    <a:pt x="13536" y="13536"/>
                  </a:cubicBezTo>
                  <a:cubicBezTo>
                    <a:pt x="22202" y="4869"/>
                    <a:pt x="33957" y="0"/>
                    <a:pt x="46213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7" name="TextBox 17"/>
            <p:cNvSpPr txBox="1"/>
            <p:nvPr/>
          </p:nvSpPr>
          <p:spPr>
            <a:xfrm>
              <a:off x="0" y="-28575"/>
              <a:ext cx="316114" cy="121002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260"/>
                </a:lnSpc>
              </a:pPr>
              <a:r>
                <a:rPr lang="en-US" sz="900" b="1">
                  <a:solidFill>
                    <a:srgbClr val="000000"/>
                  </a:solidFill>
                  <a:latin typeface="Times New Roman Bold"/>
                  <a:ea typeface="Times New Roman Bold"/>
                  <a:cs typeface="Times New Roman Bold"/>
                  <a:sym typeface="Times New Roman Bold"/>
                </a:rPr>
                <a:t>OUTBREAKS</a:t>
              </a:r>
            </a:p>
          </p:txBody>
        </p:sp>
      </p:grpSp>
      <p:grpSp>
        <p:nvGrpSpPr>
          <p:cNvPr id="18" name="Group 18"/>
          <p:cNvGrpSpPr/>
          <p:nvPr/>
        </p:nvGrpSpPr>
        <p:grpSpPr>
          <a:xfrm>
            <a:off x="5804966" y="1000634"/>
            <a:ext cx="535101" cy="356441"/>
            <a:chOff x="0" y="0"/>
            <a:chExt cx="198186" cy="132015"/>
          </a:xfrm>
        </p:grpSpPr>
        <p:sp>
          <p:nvSpPr>
            <p:cNvPr id="19" name="Freeform 19"/>
            <p:cNvSpPr/>
            <p:nvPr/>
          </p:nvSpPr>
          <p:spPr>
            <a:xfrm>
              <a:off x="0" y="0"/>
              <a:ext cx="198186" cy="132015"/>
            </a:xfrm>
            <a:custGeom>
              <a:avLst/>
              <a:gdLst/>
              <a:ahLst/>
              <a:cxnLst/>
              <a:rect l="l" t="t" r="r" b="b"/>
              <a:pathLst>
                <a:path w="198186" h="132015">
                  <a:moveTo>
                    <a:pt x="66008" y="0"/>
                  </a:moveTo>
                  <a:lnTo>
                    <a:pt x="132178" y="0"/>
                  </a:lnTo>
                  <a:cubicBezTo>
                    <a:pt x="149684" y="0"/>
                    <a:pt x="166474" y="6954"/>
                    <a:pt x="178852" y="19333"/>
                  </a:cubicBezTo>
                  <a:cubicBezTo>
                    <a:pt x="191231" y="31712"/>
                    <a:pt x="198186" y="48501"/>
                    <a:pt x="198186" y="66008"/>
                  </a:cubicBezTo>
                  <a:lnTo>
                    <a:pt x="198186" y="66008"/>
                  </a:lnTo>
                  <a:cubicBezTo>
                    <a:pt x="198186" y="102463"/>
                    <a:pt x="168633" y="132015"/>
                    <a:pt x="132178" y="132015"/>
                  </a:cubicBezTo>
                  <a:lnTo>
                    <a:pt x="66008" y="132015"/>
                  </a:lnTo>
                  <a:cubicBezTo>
                    <a:pt x="29553" y="132015"/>
                    <a:pt x="0" y="102463"/>
                    <a:pt x="0" y="66008"/>
                  </a:cubicBezTo>
                  <a:lnTo>
                    <a:pt x="0" y="66008"/>
                  </a:lnTo>
                  <a:cubicBezTo>
                    <a:pt x="0" y="29553"/>
                    <a:pt x="29553" y="0"/>
                    <a:pt x="66008" y="0"/>
                  </a:cubicBezTo>
                  <a:close/>
                </a:path>
              </a:pathLst>
            </a:custGeom>
            <a:solidFill>
              <a:srgbClr val="595959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20" name="TextBox 20"/>
            <p:cNvSpPr txBox="1"/>
            <p:nvPr/>
          </p:nvSpPr>
          <p:spPr>
            <a:xfrm>
              <a:off x="0" y="-38100"/>
              <a:ext cx="198186" cy="170115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960"/>
                </a:lnSpc>
              </a:pPr>
              <a:r>
                <a:rPr lang="en-US" sz="1400" b="1" dirty="0">
                  <a:solidFill>
                    <a:srgbClr val="FFFFFF"/>
                  </a:solidFill>
                  <a:latin typeface="Times New Roman Bold"/>
                  <a:ea typeface="Times New Roman Bold"/>
                  <a:cs typeface="Times New Roman Bold"/>
                  <a:sym typeface="Times New Roman Bold"/>
                </a:rPr>
                <a:t>356</a:t>
              </a:r>
            </a:p>
          </p:txBody>
        </p:sp>
      </p:grpSp>
      <p:grpSp>
        <p:nvGrpSpPr>
          <p:cNvPr id="21" name="Group 21"/>
          <p:cNvGrpSpPr/>
          <p:nvPr/>
        </p:nvGrpSpPr>
        <p:grpSpPr>
          <a:xfrm>
            <a:off x="6852230" y="1000634"/>
            <a:ext cx="535101" cy="356441"/>
            <a:chOff x="0" y="0"/>
            <a:chExt cx="198186" cy="132015"/>
          </a:xfrm>
        </p:grpSpPr>
        <p:sp>
          <p:nvSpPr>
            <p:cNvPr id="22" name="Freeform 22"/>
            <p:cNvSpPr/>
            <p:nvPr/>
          </p:nvSpPr>
          <p:spPr>
            <a:xfrm>
              <a:off x="0" y="0"/>
              <a:ext cx="198186" cy="132015"/>
            </a:xfrm>
            <a:custGeom>
              <a:avLst/>
              <a:gdLst/>
              <a:ahLst/>
              <a:cxnLst/>
              <a:rect l="l" t="t" r="r" b="b"/>
              <a:pathLst>
                <a:path w="198186" h="132015">
                  <a:moveTo>
                    <a:pt x="66008" y="0"/>
                  </a:moveTo>
                  <a:lnTo>
                    <a:pt x="132178" y="0"/>
                  </a:lnTo>
                  <a:cubicBezTo>
                    <a:pt x="149684" y="0"/>
                    <a:pt x="166474" y="6954"/>
                    <a:pt x="178852" y="19333"/>
                  </a:cubicBezTo>
                  <a:cubicBezTo>
                    <a:pt x="191231" y="31712"/>
                    <a:pt x="198186" y="48501"/>
                    <a:pt x="198186" y="66008"/>
                  </a:cubicBezTo>
                  <a:lnTo>
                    <a:pt x="198186" y="66008"/>
                  </a:lnTo>
                  <a:cubicBezTo>
                    <a:pt x="198186" y="102463"/>
                    <a:pt x="168633" y="132015"/>
                    <a:pt x="132178" y="132015"/>
                  </a:cubicBezTo>
                  <a:lnTo>
                    <a:pt x="66008" y="132015"/>
                  </a:lnTo>
                  <a:cubicBezTo>
                    <a:pt x="29553" y="132015"/>
                    <a:pt x="0" y="102463"/>
                    <a:pt x="0" y="66008"/>
                  </a:cubicBezTo>
                  <a:lnTo>
                    <a:pt x="0" y="66008"/>
                  </a:lnTo>
                  <a:cubicBezTo>
                    <a:pt x="0" y="29553"/>
                    <a:pt x="29553" y="0"/>
                    <a:pt x="66008" y="0"/>
                  </a:cubicBezTo>
                  <a:close/>
                </a:path>
              </a:pathLst>
            </a:custGeom>
            <a:solidFill>
              <a:srgbClr val="595959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23" name="TextBox 23"/>
            <p:cNvSpPr txBox="1"/>
            <p:nvPr/>
          </p:nvSpPr>
          <p:spPr>
            <a:xfrm>
              <a:off x="0" y="-38100"/>
              <a:ext cx="198186" cy="170115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960"/>
                </a:lnSpc>
              </a:pPr>
              <a:r>
                <a:rPr lang="en-US" sz="1400" b="1">
                  <a:solidFill>
                    <a:srgbClr val="FFFFFF"/>
                  </a:solidFill>
                  <a:latin typeface="Times New Roman Bold"/>
                  <a:ea typeface="Times New Roman Bold"/>
                  <a:cs typeface="Times New Roman Bold"/>
                  <a:sym typeface="Times New Roman Bold"/>
                </a:rPr>
                <a:t>33</a:t>
              </a:r>
            </a:p>
          </p:txBody>
        </p:sp>
      </p:grpSp>
      <p:grpSp>
        <p:nvGrpSpPr>
          <p:cNvPr id="24" name="Group 24"/>
          <p:cNvGrpSpPr/>
          <p:nvPr/>
        </p:nvGrpSpPr>
        <p:grpSpPr>
          <a:xfrm>
            <a:off x="7799824" y="927792"/>
            <a:ext cx="557202" cy="419249"/>
            <a:chOff x="-33571" y="-95403"/>
            <a:chExt cx="846371" cy="636824"/>
          </a:xfrm>
        </p:grpSpPr>
        <p:sp>
          <p:nvSpPr>
            <p:cNvPr id="25" name="Freeform 25"/>
            <p:cNvSpPr/>
            <p:nvPr/>
          </p:nvSpPr>
          <p:spPr>
            <a:xfrm>
              <a:off x="0" y="0"/>
              <a:ext cx="812800" cy="541421"/>
            </a:xfrm>
            <a:custGeom>
              <a:avLst/>
              <a:gdLst/>
              <a:ahLst/>
              <a:cxnLst/>
              <a:rect l="l" t="t" r="r" b="b"/>
              <a:pathLst>
                <a:path w="812800" h="541421">
                  <a:moveTo>
                    <a:pt x="0" y="0"/>
                  </a:moveTo>
                  <a:lnTo>
                    <a:pt x="812800" y="0"/>
                  </a:lnTo>
                  <a:lnTo>
                    <a:pt x="812800" y="541421"/>
                  </a:lnTo>
                  <a:lnTo>
                    <a:pt x="0" y="541421"/>
                  </a:lnTo>
                  <a:close/>
                </a:path>
              </a:pathLst>
            </a:custGeom>
            <a:solidFill>
              <a:srgbClr val="595959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26" name="TextBox 26"/>
            <p:cNvSpPr txBox="1"/>
            <p:nvPr/>
          </p:nvSpPr>
          <p:spPr>
            <a:xfrm>
              <a:off x="-33571" y="-95403"/>
              <a:ext cx="812800" cy="579521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960"/>
                </a:lnSpc>
              </a:pPr>
              <a:r>
                <a:rPr lang="en-US" sz="1400" b="1" dirty="0">
                  <a:solidFill>
                    <a:srgbClr val="FFFFFF"/>
                  </a:solidFill>
                  <a:latin typeface="Times New Roman Bold"/>
                  <a:ea typeface="Times New Roman Bold"/>
                  <a:cs typeface="Times New Roman Bold"/>
                  <a:sym typeface="Times New Roman Bold"/>
                </a:rPr>
                <a:t>127</a:t>
              </a:r>
            </a:p>
          </p:txBody>
        </p:sp>
      </p:grpSp>
      <p:grpSp>
        <p:nvGrpSpPr>
          <p:cNvPr id="27" name="Group 27"/>
          <p:cNvGrpSpPr/>
          <p:nvPr/>
        </p:nvGrpSpPr>
        <p:grpSpPr>
          <a:xfrm>
            <a:off x="1478383" y="1019739"/>
            <a:ext cx="677605" cy="356441"/>
            <a:chOff x="0" y="0"/>
            <a:chExt cx="250965" cy="132015"/>
          </a:xfrm>
        </p:grpSpPr>
        <p:sp>
          <p:nvSpPr>
            <p:cNvPr id="28" name="Freeform 28"/>
            <p:cNvSpPr/>
            <p:nvPr/>
          </p:nvSpPr>
          <p:spPr>
            <a:xfrm>
              <a:off x="0" y="0"/>
              <a:ext cx="250965" cy="132015"/>
            </a:xfrm>
            <a:custGeom>
              <a:avLst/>
              <a:gdLst/>
              <a:ahLst/>
              <a:cxnLst/>
              <a:rect l="l" t="t" r="r" b="b"/>
              <a:pathLst>
                <a:path w="250965" h="132015">
                  <a:moveTo>
                    <a:pt x="66008" y="0"/>
                  </a:moveTo>
                  <a:lnTo>
                    <a:pt x="184957" y="0"/>
                  </a:lnTo>
                  <a:cubicBezTo>
                    <a:pt x="221412" y="0"/>
                    <a:pt x="250965" y="29553"/>
                    <a:pt x="250965" y="66008"/>
                  </a:cubicBezTo>
                  <a:lnTo>
                    <a:pt x="250965" y="66008"/>
                  </a:lnTo>
                  <a:cubicBezTo>
                    <a:pt x="250965" y="83514"/>
                    <a:pt x="244011" y="100303"/>
                    <a:pt x="231632" y="112682"/>
                  </a:cubicBezTo>
                  <a:cubicBezTo>
                    <a:pt x="219253" y="125061"/>
                    <a:pt x="202464" y="132015"/>
                    <a:pt x="184957" y="132015"/>
                  </a:cubicBezTo>
                  <a:lnTo>
                    <a:pt x="66008" y="132015"/>
                  </a:lnTo>
                  <a:cubicBezTo>
                    <a:pt x="29553" y="132015"/>
                    <a:pt x="0" y="102463"/>
                    <a:pt x="0" y="66008"/>
                  </a:cubicBezTo>
                  <a:lnTo>
                    <a:pt x="0" y="66008"/>
                  </a:lnTo>
                  <a:cubicBezTo>
                    <a:pt x="0" y="29553"/>
                    <a:pt x="29553" y="0"/>
                    <a:pt x="66008" y="0"/>
                  </a:cubicBezTo>
                  <a:close/>
                </a:path>
              </a:pathLst>
            </a:custGeom>
            <a:solidFill>
              <a:srgbClr val="595959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29" name="TextBox 29"/>
            <p:cNvSpPr txBox="1"/>
            <p:nvPr/>
          </p:nvSpPr>
          <p:spPr>
            <a:xfrm>
              <a:off x="0" y="-38100"/>
              <a:ext cx="250965" cy="170115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960"/>
                </a:lnSpc>
              </a:pPr>
              <a:r>
                <a:rPr lang="en-US" sz="1400" b="1">
                  <a:solidFill>
                    <a:srgbClr val="FFFFFF"/>
                  </a:solidFill>
                  <a:latin typeface="Times New Roman Bold"/>
                  <a:ea typeface="Times New Roman Bold"/>
                  <a:cs typeface="Times New Roman Bold"/>
                  <a:sym typeface="Times New Roman Bold"/>
                </a:rPr>
                <a:t>20,231</a:t>
              </a:r>
            </a:p>
          </p:txBody>
        </p:sp>
      </p:grpSp>
      <p:grpSp>
        <p:nvGrpSpPr>
          <p:cNvPr id="30" name="Group 30"/>
          <p:cNvGrpSpPr/>
          <p:nvPr/>
        </p:nvGrpSpPr>
        <p:grpSpPr>
          <a:xfrm>
            <a:off x="2299407" y="1014962"/>
            <a:ext cx="535101" cy="356441"/>
            <a:chOff x="0" y="0"/>
            <a:chExt cx="198186" cy="132015"/>
          </a:xfrm>
        </p:grpSpPr>
        <p:sp>
          <p:nvSpPr>
            <p:cNvPr id="31" name="Freeform 31"/>
            <p:cNvSpPr/>
            <p:nvPr/>
          </p:nvSpPr>
          <p:spPr>
            <a:xfrm>
              <a:off x="0" y="0"/>
              <a:ext cx="198186" cy="132015"/>
            </a:xfrm>
            <a:custGeom>
              <a:avLst/>
              <a:gdLst/>
              <a:ahLst/>
              <a:cxnLst/>
              <a:rect l="l" t="t" r="r" b="b"/>
              <a:pathLst>
                <a:path w="198186" h="132015">
                  <a:moveTo>
                    <a:pt x="66008" y="0"/>
                  </a:moveTo>
                  <a:lnTo>
                    <a:pt x="132178" y="0"/>
                  </a:lnTo>
                  <a:cubicBezTo>
                    <a:pt x="149684" y="0"/>
                    <a:pt x="166474" y="6954"/>
                    <a:pt x="178852" y="19333"/>
                  </a:cubicBezTo>
                  <a:cubicBezTo>
                    <a:pt x="191231" y="31712"/>
                    <a:pt x="198186" y="48501"/>
                    <a:pt x="198186" y="66008"/>
                  </a:cubicBezTo>
                  <a:lnTo>
                    <a:pt x="198186" y="66008"/>
                  </a:lnTo>
                  <a:cubicBezTo>
                    <a:pt x="198186" y="102463"/>
                    <a:pt x="168633" y="132015"/>
                    <a:pt x="132178" y="132015"/>
                  </a:cubicBezTo>
                  <a:lnTo>
                    <a:pt x="66008" y="132015"/>
                  </a:lnTo>
                  <a:cubicBezTo>
                    <a:pt x="29553" y="132015"/>
                    <a:pt x="0" y="102463"/>
                    <a:pt x="0" y="66008"/>
                  </a:cubicBezTo>
                  <a:lnTo>
                    <a:pt x="0" y="66008"/>
                  </a:lnTo>
                  <a:cubicBezTo>
                    <a:pt x="0" y="29553"/>
                    <a:pt x="29553" y="0"/>
                    <a:pt x="66008" y="0"/>
                  </a:cubicBezTo>
                  <a:close/>
                </a:path>
              </a:pathLst>
            </a:custGeom>
            <a:solidFill>
              <a:srgbClr val="595959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32" name="TextBox 32"/>
            <p:cNvSpPr txBox="1"/>
            <p:nvPr/>
          </p:nvSpPr>
          <p:spPr>
            <a:xfrm>
              <a:off x="0" y="-38100"/>
              <a:ext cx="198186" cy="170115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960"/>
                </a:lnSpc>
              </a:pPr>
              <a:r>
                <a:rPr lang="en-US" sz="1400" b="1" dirty="0">
                  <a:solidFill>
                    <a:srgbClr val="FFFFFF"/>
                  </a:solidFill>
                  <a:latin typeface="Times New Roman Bold"/>
                  <a:ea typeface="Times New Roman Bold"/>
                  <a:cs typeface="Times New Roman Bold"/>
                  <a:sym typeface="Times New Roman Bold"/>
                </a:rPr>
                <a:t>177</a:t>
              </a:r>
            </a:p>
          </p:txBody>
        </p:sp>
      </p:grpSp>
      <p:grpSp>
        <p:nvGrpSpPr>
          <p:cNvPr id="33" name="Group 33"/>
          <p:cNvGrpSpPr/>
          <p:nvPr/>
        </p:nvGrpSpPr>
        <p:grpSpPr>
          <a:xfrm>
            <a:off x="3051245" y="944148"/>
            <a:ext cx="563677" cy="395770"/>
            <a:chOff x="-43406" y="-59739"/>
            <a:chExt cx="856206" cy="601160"/>
          </a:xfrm>
        </p:grpSpPr>
        <p:sp>
          <p:nvSpPr>
            <p:cNvPr id="34" name="Freeform 34"/>
            <p:cNvSpPr/>
            <p:nvPr/>
          </p:nvSpPr>
          <p:spPr>
            <a:xfrm>
              <a:off x="0" y="0"/>
              <a:ext cx="812800" cy="541421"/>
            </a:xfrm>
            <a:custGeom>
              <a:avLst/>
              <a:gdLst/>
              <a:ahLst/>
              <a:cxnLst/>
              <a:rect l="l" t="t" r="r" b="b"/>
              <a:pathLst>
                <a:path w="812800" h="541421">
                  <a:moveTo>
                    <a:pt x="0" y="0"/>
                  </a:moveTo>
                  <a:lnTo>
                    <a:pt x="812800" y="0"/>
                  </a:lnTo>
                  <a:lnTo>
                    <a:pt x="812800" y="541421"/>
                  </a:lnTo>
                  <a:lnTo>
                    <a:pt x="0" y="541421"/>
                  </a:lnTo>
                  <a:close/>
                </a:path>
              </a:pathLst>
            </a:custGeom>
            <a:solidFill>
              <a:srgbClr val="595959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35" name="TextBox 35"/>
            <p:cNvSpPr txBox="1"/>
            <p:nvPr/>
          </p:nvSpPr>
          <p:spPr>
            <a:xfrm>
              <a:off x="-43406" y="-59739"/>
              <a:ext cx="812800" cy="579521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960"/>
                </a:lnSpc>
              </a:pPr>
              <a:r>
                <a:rPr lang="en-US" sz="1400" b="1" dirty="0">
                  <a:solidFill>
                    <a:srgbClr val="FFFFFF"/>
                  </a:solidFill>
                  <a:latin typeface="Times New Roman Bold"/>
                  <a:ea typeface="Times New Roman Bold"/>
                  <a:cs typeface="Times New Roman Bold"/>
                  <a:sym typeface="Times New Roman Bold"/>
                </a:rPr>
                <a:t>0</a:t>
              </a:r>
            </a:p>
          </p:txBody>
        </p:sp>
      </p:grpSp>
      <p:sp>
        <p:nvSpPr>
          <p:cNvPr id="36" name="TextBox 36"/>
          <p:cNvSpPr txBox="1"/>
          <p:nvPr/>
        </p:nvSpPr>
        <p:spPr>
          <a:xfrm>
            <a:off x="8039667" y="6239977"/>
            <a:ext cx="874942" cy="184150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1400"/>
              </a:lnSpc>
              <a:spcBef>
                <a:spcPct val="0"/>
              </a:spcBef>
            </a:pPr>
            <a:r>
              <a:rPr lang="en-US" sz="1000">
                <a:solidFill>
                  <a:srgbClr val="FFFFFF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No case</a:t>
            </a:r>
          </a:p>
        </p:txBody>
      </p:sp>
      <p:sp>
        <p:nvSpPr>
          <p:cNvPr id="37" name="TextBox 37"/>
          <p:cNvSpPr txBox="1"/>
          <p:nvPr/>
        </p:nvSpPr>
        <p:spPr>
          <a:xfrm>
            <a:off x="8147138" y="6386029"/>
            <a:ext cx="874942" cy="184150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1400"/>
              </a:lnSpc>
              <a:spcBef>
                <a:spcPct val="0"/>
              </a:spcBef>
            </a:pPr>
            <a:r>
              <a:rPr lang="en-US" sz="1000">
                <a:solidFill>
                  <a:srgbClr val="FFFFFF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ases &lt; 500</a:t>
            </a:r>
          </a:p>
        </p:txBody>
      </p:sp>
      <p:sp>
        <p:nvSpPr>
          <p:cNvPr id="38" name="TextBox 38"/>
          <p:cNvSpPr txBox="1"/>
          <p:nvPr/>
        </p:nvSpPr>
        <p:spPr>
          <a:xfrm>
            <a:off x="8147138" y="6529541"/>
            <a:ext cx="874942" cy="184150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1400"/>
              </a:lnSpc>
              <a:spcBef>
                <a:spcPct val="0"/>
              </a:spcBef>
            </a:pPr>
            <a:r>
              <a:rPr lang="en-US" sz="1000">
                <a:solidFill>
                  <a:srgbClr val="FFFFFF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ases &gt; 500</a:t>
            </a:r>
          </a:p>
        </p:txBody>
      </p:sp>
      <p:sp>
        <p:nvSpPr>
          <p:cNvPr id="39" name="TextBox 39"/>
          <p:cNvSpPr txBox="1"/>
          <p:nvPr/>
        </p:nvSpPr>
        <p:spPr>
          <a:xfrm>
            <a:off x="8186181" y="6672416"/>
            <a:ext cx="874942" cy="184150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1400"/>
              </a:lnSpc>
              <a:spcBef>
                <a:spcPct val="0"/>
              </a:spcBef>
            </a:pPr>
            <a:r>
              <a:rPr lang="en-US" sz="1000">
                <a:solidFill>
                  <a:srgbClr val="FFFFFF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ases &gt; 1000</a:t>
            </a:r>
          </a:p>
        </p:txBody>
      </p:sp>
      <p:grpSp>
        <p:nvGrpSpPr>
          <p:cNvPr id="40" name="Group 40"/>
          <p:cNvGrpSpPr/>
          <p:nvPr/>
        </p:nvGrpSpPr>
        <p:grpSpPr>
          <a:xfrm>
            <a:off x="7600416" y="6300434"/>
            <a:ext cx="549951" cy="102488"/>
            <a:chOff x="0" y="0"/>
            <a:chExt cx="214684" cy="40008"/>
          </a:xfrm>
        </p:grpSpPr>
        <p:sp>
          <p:nvSpPr>
            <p:cNvPr id="41" name="Freeform 41"/>
            <p:cNvSpPr/>
            <p:nvPr/>
          </p:nvSpPr>
          <p:spPr>
            <a:xfrm>
              <a:off x="0" y="0"/>
              <a:ext cx="214684" cy="40008"/>
            </a:xfrm>
            <a:custGeom>
              <a:avLst/>
              <a:gdLst/>
              <a:ahLst/>
              <a:cxnLst/>
              <a:rect l="l" t="t" r="r" b="b"/>
              <a:pathLst>
                <a:path w="214684" h="40008">
                  <a:moveTo>
                    <a:pt x="0" y="0"/>
                  </a:moveTo>
                  <a:lnTo>
                    <a:pt x="214684" y="0"/>
                  </a:lnTo>
                  <a:lnTo>
                    <a:pt x="214684" y="40008"/>
                  </a:lnTo>
                  <a:lnTo>
                    <a:pt x="0" y="40008"/>
                  </a:lnTo>
                  <a:close/>
                </a:path>
              </a:pathLst>
            </a:custGeom>
            <a:solidFill>
              <a:srgbClr val="D9D9D9"/>
            </a:solidFill>
            <a:ln w="28575" cap="sq">
              <a:solidFill>
                <a:srgbClr val="595959"/>
              </a:solidFill>
              <a:prstDash val="solid"/>
              <a:miter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2" name="TextBox 42"/>
            <p:cNvSpPr txBox="1"/>
            <p:nvPr/>
          </p:nvSpPr>
          <p:spPr>
            <a:xfrm>
              <a:off x="0" y="-28575"/>
              <a:ext cx="214684" cy="68583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2100"/>
                </a:lnSpc>
              </a:pPr>
              <a:endParaRPr/>
            </a:p>
          </p:txBody>
        </p:sp>
      </p:grpSp>
      <p:grpSp>
        <p:nvGrpSpPr>
          <p:cNvPr id="43" name="Group 43"/>
          <p:cNvGrpSpPr/>
          <p:nvPr/>
        </p:nvGrpSpPr>
        <p:grpSpPr>
          <a:xfrm>
            <a:off x="7600416" y="6431741"/>
            <a:ext cx="549951" cy="102488"/>
            <a:chOff x="0" y="0"/>
            <a:chExt cx="214684" cy="40008"/>
          </a:xfrm>
        </p:grpSpPr>
        <p:sp>
          <p:nvSpPr>
            <p:cNvPr id="44" name="Freeform 44"/>
            <p:cNvSpPr/>
            <p:nvPr/>
          </p:nvSpPr>
          <p:spPr>
            <a:xfrm>
              <a:off x="0" y="0"/>
              <a:ext cx="214684" cy="40008"/>
            </a:xfrm>
            <a:custGeom>
              <a:avLst/>
              <a:gdLst/>
              <a:ahLst/>
              <a:cxnLst/>
              <a:rect l="l" t="t" r="r" b="b"/>
              <a:pathLst>
                <a:path w="214684" h="40008">
                  <a:moveTo>
                    <a:pt x="0" y="0"/>
                  </a:moveTo>
                  <a:lnTo>
                    <a:pt x="214684" y="0"/>
                  </a:lnTo>
                  <a:lnTo>
                    <a:pt x="214684" y="40008"/>
                  </a:lnTo>
                  <a:lnTo>
                    <a:pt x="0" y="40008"/>
                  </a:lnTo>
                  <a:close/>
                </a:path>
              </a:pathLst>
            </a:custGeom>
            <a:solidFill>
              <a:srgbClr val="DDBEBE"/>
            </a:solidFill>
            <a:ln w="28575" cap="sq">
              <a:solidFill>
                <a:srgbClr val="595959"/>
              </a:solidFill>
              <a:prstDash val="solid"/>
              <a:miter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" name="TextBox 45"/>
            <p:cNvSpPr txBox="1"/>
            <p:nvPr/>
          </p:nvSpPr>
          <p:spPr>
            <a:xfrm>
              <a:off x="0" y="-28575"/>
              <a:ext cx="214684" cy="68583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2100"/>
                </a:lnSpc>
              </a:pPr>
              <a:endParaRPr/>
            </a:p>
          </p:txBody>
        </p:sp>
      </p:grpSp>
      <p:grpSp>
        <p:nvGrpSpPr>
          <p:cNvPr id="46" name="Group 46"/>
          <p:cNvGrpSpPr/>
          <p:nvPr/>
        </p:nvGrpSpPr>
        <p:grpSpPr>
          <a:xfrm>
            <a:off x="7600416" y="6584587"/>
            <a:ext cx="549951" cy="102488"/>
            <a:chOff x="0" y="0"/>
            <a:chExt cx="214684" cy="40008"/>
          </a:xfrm>
        </p:grpSpPr>
        <p:sp>
          <p:nvSpPr>
            <p:cNvPr id="47" name="Freeform 47"/>
            <p:cNvSpPr/>
            <p:nvPr/>
          </p:nvSpPr>
          <p:spPr>
            <a:xfrm>
              <a:off x="0" y="0"/>
              <a:ext cx="214684" cy="40008"/>
            </a:xfrm>
            <a:custGeom>
              <a:avLst/>
              <a:gdLst/>
              <a:ahLst/>
              <a:cxnLst/>
              <a:rect l="l" t="t" r="r" b="b"/>
              <a:pathLst>
                <a:path w="214684" h="40008">
                  <a:moveTo>
                    <a:pt x="0" y="0"/>
                  </a:moveTo>
                  <a:lnTo>
                    <a:pt x="214684" y="0"/>
                  </a:lnTo>
                  <a:lnTo>
                    <a:pt x="214684" y="40008"/>
                  </a:lnTo>
                  <a:lnTo>
                    <a:pt x="0" y="40008"/>
                  </a:lnTo>
                  <a:close/>
                </a:path>
              </a:pathLst>
            </a:custGeom>
            <a:solidFill>
              <a:srgbClr val="D68F8D"/>
            </a:solidFill>
            <a:ln w="28575" cap="sq">
              <a:solidFill>
                <a:srgbClr val="595959"/>
              </a:solidFill>
              <a:prstDash val="solid"/>
              <a:miter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" name="TextBox 48"/>
            <p:cNvSpPr txBox="1"/>
            <p:nvPr/>
          </p:nvSpPr>
          <p:spPr>
            <a:xfrm>
              <a:off x="0" y="-28575"/>
              <a:ext cx="214684" cy="68583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2100"/>
                </a:lnSpc>
              </a:pPr>
              <a:endParaRPr/>
            </a:p>
          </p:txBody>
        </p:sp>
      </p:grpSp>
      <p:grpSp>
        <p:nvGrpSpPr>
          <p:cNvPr id="49" name="Group 49"/>
          <p:cNvGrpSpPr/>
          <p:nvPr/>
        </p:nvGrpSpPr>
        <p:grpSpPr>
          <a:xfrm>
            <a:off x="7600416" y="6737434"/>
            <a:ext cx="549951" cy="102488"/>
            <a:chOff x="0" y="0"/>
            <a:chExt cx="214684" cy="40008"/>
          </a:xfrm>
        </p:grpSpPr>
        <p:sp>
          <p:nvSpPr>
            <p:cNvPr id="50" name="Freeform 50"/>
            <p:cNvSpPr/>
            <p:nvPr/>
          </p:nvSpPr>
          <p:spPr>
            <a:xfrm>
              <a:off x="0" y="0"/>
              <a:ext cx="214684" cy="40008"/>
            </a:xfrm>
            <a:custGeom>
              <a:avLst/>
              <a:gdLst/>
              <a:ahLst/>
              <a:cxnLst/>
              <a:rect l="l" t="t" r="r" b="b"/>
              <a:pathLst>
                <a:path w="214684" h="40008">
                  <a:moveTo>
                    <a:pt x="0" y="0"/>
                  </a:moveTo>
                  <a:lnTo>
                    <a:pt x="214684" y="0"/>
                  </a:lnTo>
                  <a:lnTo>
                    <a:pt x="214684" y="40008"/>
                  </a:lnTo>
                  <a:lnTo>
                    <a:pt x="0" y="40008"/>
                  </a:lnTo>
                  <a:close/>
                </a:path>
              </a:pathLst>
            </a:custGeom>
            <a:solidFill>
              <a:srgbClr val="FF3131"/>
            </a:solidFill>
            <a:ln w="28575" cap="sq">
              <a:solidFill>
                <a:srgbClr val="595959"/>
              </a:solidFill>
              <a:prstDash val="solid"/>
              <a:miter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" name="TextBox 51"/>
            <p:cNvSpPr txBox="1"/>
            <p:nvPr/>
          </p:nvSpPr>
          <p:spPr>
            <a:xfrm>
              <a:off x="0" y="-28575"/>
              <a:ext cx="214684" cy="68583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2100"/>
                </a:lnSpc>
              </a:pPr>
              <a:endParaRPr/>
            </a:p>
          </p:txBody>
        </p:sp>
      </p:grpSp>
      <p:sp>
        <p:nvSpPr>
          <p:cNvPr id="52" name="AutoShape 52"/>
          <p:cNvSpPr/>
          <p:nvPr/>
        </p:nvSpPr>
        <p:spPr>
          <a:xfrm flipV="1">
            <a:off x="345564" y="2638412"/>
            <a:ext cx="0" cy="988119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53" name="Group 53"/>
          <p:cNvGrpSpPr/>
          <p:nvPr/>
        </p:nvGrpSpPr>
        <p:grpSpPr>
          <a:xfrm>
            <a:off x="312138" y="3615299"/>
            <a:ext cx="67516" cy="67516"/>
            <a:chOff x="0" y="0"/>
            <a:chExt cx="812800" cy="812800"/>
          </a:xfrm>
        </p:grpSpPr>
        <p:sp>
          <p:nvSpPr>
            <p:cNvPr id="54" name="Freeform 54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55" name="TextBox 55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56" name="AutoShape 56"/>
          <p:cNvSpPr/>
          <p:nvPr/>
        </p:nvSpPr>
        <p:spPr>
          <a:xfrm flipH="1" flipV="1">
            <a:off x="785093" y="2256912"/>
            <a:ext cx="0" cy="730118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57" name="Group 57"/>
          <p:cNvGrpSpPr/>
          <p:nvPr/>
        </p:nvGrpSpPr>
        <p:grpSpPr>
          <a:xfrm>
            <a:off x="751335" y="2207066"/>
            <a:ext cx="67516" cy="67516"/>
            <a:chOff x="0" y="0"/>
            <a:chExt cx="812800" cy="812800"/>
          </a:xfrm>
        </p:grpSpPr>
        <p:sp>
          <p:nvSpPr>
            <p:cNvPr id="58" name="Freeform 58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59" name="TextBox 59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60" name="AutoShape 60"/>
          <p:cNvSpPr/>
          <p:nvPr/>
        </p:nvSpPr>
        <p:spPr>
          <a:xfrm flipV="1">
            <a:off x="4696132" y="5444122"/>
            <a:ext cx="5088" cy="768605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61" name="Group 61"/>
          <p:cNvGrpSpPr/>
          <p:nvPr/>
        </p:nvGrpSpPr>
        <p:grpSpPr>
          <a:xfrm>
            <a:off x="4662375" y="6168462"/>
            <a:ext cx="67516" cy="67516"/>
            <a:chOff x="0" y="0"/>
            <a:chExt cx="812800" cy="812800"/>
          </a:xfrm>
        </p:grpSpPr>
        <p:sp>
          <p:nvSpPr>
            <p:cNvPr id="62" name="Freeform 62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63" name="TextBox 63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64" name="AutoShape 64"/>
          <p:cNvSpPr/>
          <p:nvPr/>
        </p:nvSpPr>
        <p:spPr>
          <a:xfrm flipH="1" flipV="1">
            <a:off x="1512140" y="2466679"/>
            <a:ext cx="11814" cy="1067038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65" name="Group 65"/>
          <p:cNvGrpSpPr/>
          <p:nvPr/>
        </p:nvGrpSpPr>
        <p:grpSpPr>
          <a:xfrm>
            <a:off x="1478383" y="2416833"/>
            <a:ext cx="67516" cy="67516"/>
            <a:chOff x="0" y="0"/>
            <a:chExt cx="812800" cy="812800"/>
          </a:xfrm>
        </p:grpSpPr>
        <p:sp>
          <p:nvSpPr>
            <p:cNvPr id="66" name="Freeform 66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67" name="TextBox 67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grpSp>
        <p:nvGrpSpPr>
          <p:cNvPr id="68" name="Group 68"/>
          <p:cNvGrpSpPr/>
          <p:nvPr/>
        </p:nvGrpSpPr>
        <p:grpSpPr>
          <a:xfrm>
            <a:off x="2354072" y="2249192"/>
            <a:ext cx="67516" cy="67516"/>
            <a:chOff x="0" y="0"/>
            <a:chExt cx="812800" cy="812800"/>
          </a:xfrm>
        </p:grpSpPr>
        <p:sp>
          <p:nvSpPr>
            <p:cNvPr id="69" name="Freeform 69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70" name="TextBox 70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grpSp>
        <p:nvGrpSpPr>
          <p:cNvPr id="71" name="Group 71"/>
          <p:cNvGrpSpPr/>
          <p:nvPr/>
        </p:nvGrpSpPr>
        <p:grpSpPr>
          <a:xfrm>
            <a:off x="2440520" y="3714750"/>
            <a:ext cx="67516" cy="67516"/>
            <a:chOff x="0" y="0"/>
            <a:chExt cx="812800" cy="812800"/>
          </a:xfrm>
        </p:grpSpPr>
        <p:sp>
          <p:nvSpPr>
            <p:cNvPr id="72" name="Freeform 72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73" name="TextBox 73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74" name="AutoShape 74"/>
          <p:cNvSpPr/>
          <p:nvPr/>
        </p:nvSpPr>
        <p:spPr>
          <a:xfrm flipV="1">
            <a:off x="2474278" y="3738966"/>
            <a:ext cx="0" cy="456697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sp>
        <p:nvSpPr>
          <p:cNvPr id="75" name="AutoShape 75"/>
          <p:cNvSpPr/>
          <p:nvPr/>
        </p:nvSpPr>
        <p:spPr>
          <a:xfrm flipV="1">
            <a:off x="3291013" y="2302425"/>
            <a:ext cx="0" cy="1370865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76" name="Group 76"/>
          <p:cNvGrpSpPr/>
          <p:nvPr/>
        </p:nvGrpSpPr>
        <p:grpSpPr>
          <a:xfrm>
            <a:off x="3257255" y="2239469"/>
            <a:ext cx="67516" cy="67516"/>
            <a:chOff x="0" y="0"/>
            <a:chExt cx="812800" cy="812800"/>
          </a:xfrm>
        </p:grpSpPr>
        <p:sp>
          <p:nvSpPr>
            <p:cNvPr id="77" name="Freeform 77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78" name="TextBox 78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79" name="AutoShape 79"/>
          <p:cNvSpPr/>
          <p:nvPr/>
        </p:nvSpPr>
        <p:spPr>
          <a:xfrm flipH="1" flipV="1">
            <a:off x="3855157" y="2913522"/>
            <a:ext cx="3876" cy="1081803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80" name="Group 80"/>
          <p:cNvGrpSpPr/>
          <p:nvPr/>
        </p:nvGrpSpPr>
        <p:grpSpPr>
          <a:xfrm>
            <a:off x="3825275" y="2892454"/>
            <a:ext cx="67516" cy="67516"/>
            <a:chOff x="0" y="0"/>
            <a:chExt cx="812800" cy="812800"/>
          </a:xfrm>
        </p:grpSpPr>
        <p:sp>
          <p:nvSpPr>
            <p:cNvPr id="81" name="Freeform 81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82" name="TextBox 82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83" name="AutoShape 83"/>
          <p:cNvSpPr/>
          <p:nvPr/>
        </p:nvSpPr>
        <p:spPr>
          <a:xfrm flipV="1">
            <a:off x="4538268" y="2289939"/>
            <a:ext cx="4762" cy="724955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84" name="Group 84"/>
          <p:cNvGrpSpPr/>
          <p:nvPr/>
        </p:nvGrpSpPr>
        <p:grpSpPr>
          <a:xfrm>
            <a:off x="4509273" y="2273227"/>
            <a:ext cx="67516" cy="67516"/>
            <a:chOff x="0" y="0"/>
            <a:chExt cx="812800" cy="812800"/>
          </a:xfrm>
        </p:grpSpPr>
        <p:sp>
          <p:nvSpPr>
            <p:cNvPr id="85" name="Freeform 85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86" name="TextBox 86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87" name="AutoShape 87"/>
          <p:cNvSpPr/>
          <p:nvPr/>
        </p:nvSpPr>
        <p:spPr>
          <a:xfrm>
            <a:off x="824746" y="3835835"/>
            <a:ext cx="511889" cy="3158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sp>
        <p:nvSpPr>
          <p:cNvPr id="88" name="AutoShape 88"/>
          <p:cNvSpPr/>
          <p:nvPr/>
        </p:nvSpPr>
        <p:spPr>
          <a:xfrm flipV="1">
            <a:off x="829509" y="3825690"/>
            <a:ext cx="0" cy="456697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89" name="Group 89"/>
          <p:cNvGrpSpPr/>
          <p:nvPr/>
        </p:nvGrpSpPr>
        <p:grpSpPr>
          <a:xfrm>
            <a:off x="790988" y="4225025"/>
            <a:ext cx="67516" cy="67516"/>
            <a:chOff x="0" y="0"/>
            <a:chExt cx="812800" cy="812800"/>
          </a:xfrm>
        </p:grpSpPr>
        <p:sp>
          <p:nvSpPr>
            <p:cNvPr id="90" name="Freeform 90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91" name="TextBox 91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92" name="AutoShape 92"/>
          <p:cNvSpPr/>
          <p:nvPr/>
        </p:nvSpPr>
        <p:spPr>
          <a:xfrm>
            <a:off x="1124890" y="4363978"/>
            <a:ext cx="511889" cy="3158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sp>
        <p:nvSpPr>
          <p:cNvPr id="93" name="AutoShape 93"/>
          <p:cNvSpPr/>
          <p:nvPr/>
        </p:nvSpPr>
        <p:spPr>
          <a:xfrm flipH="1" flipV="1">
            <a:off x="1121791" y="4364016"/>
            <a:ext cx="3069" cy="384136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94" name="Group 94"/>
          <p:cNvGrpSpPr/>
          <p:nvPr/>
        </p:nvGrpSpPr>
        <p:grpSpPr>
          <a:xfrm>
            <a:off x="1088033" y="4686429"/>
            <a:ext cx="67516" cy="67516"/>
            <a:chOff x="0" y="0"/>
            <a:chExt cx="812800" cy="812800"/>
          </a:xfrm>
        </p:grpSpPr>
        <p:sp>
          <p:nvSpPr>
            <p:cNvPr id="95" name="Freeform 95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96" name="TextBox 96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97" name="AutoShape 97"/>
          <p:cNvSpPr/>
          <p:nvPr/>
        </p:nvSpPr>
        <p:spPr>
          <a:xfrm flipH="1" flipV="1">
            <a:off x="1836722" y="4243858"/>
            <a:ext cx="11814" cy="1067038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sp>
        <p:nvSpPr>
          <p:cNvPr id="98" name="AutoShape 98"/>
          <p:cNvSpPr/>
          <p:nvPr/>
        </p:nvSpPr>
        <p:spPr>
          <a:xfrm flipV="1">
            <a:off x="963499" y="5306133"/>
            <a:ext cx="889808" cy="4762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99" name="Group 99"/>
          <p:cNvGrpSpPr/>
          <p:nvPr/>
        </p:nvGrpSpPr>
        <p:grpSpPr>
          <a:xfrm>
            <a:off x="952880" y="5272375"/>
            <a:ext cx="67516" cy="67516"/>
            <a:chOff x="0" y="0"/>
            <a:chExt cx="812800" cy="812800"/>
          </a:xfrm>
        </p:grpSpPr>
        <p:sp>
          <p:nvSpPr>
            <p:cNvPr id="100" name="Freeform 100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01" name="TextBox 101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02" name="AutoShape 102"/>
          <p:cNvSpPr/>
          <p:nvPr/>
        </p:nvSpPr>
        <p:spPr>
          <a:xfrm flipH="1" flipV="1">
            <a:off x="2116282" y="4696607"/>
            <a:ext cx="11092" cy="882763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sp>
        <p:nvSpPr>
          <p:cNvPr id="103" name="AutoShape 103"/>
          <p:cNvSpPr/>
          <p:nvPr/>
        </p:nvSpPr>
        <p:spPr>
          <a:xfrm>
            <a:off x="1743225" y="5575164"/>
            <a:ext cx="384148" cy="0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104" name="Group 104"/>
          <p:cNvGrpSpPr/>
          <p:nvPr/>
        </p:nvGrpSpPr>
        <p:grpSpPr>
          <a:xfrm>
            <a:off x="1701104" y="5541406"/>
            <a:ext cx="67516" cy="67516"/>
            <a:chOff x="0" y="0"/>
            <a:chExt cx="812800" cy="812800"/>
          </a:xfrm>
        </p:grpSpPr>
        <p:sp>
          <p:nvSpPr>
            <p:cNvPr id="105" name="Freeform 105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06" name="TextBox 106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07" name="AutoShape 107"/>
          <p:cNvSpPr/>
          <p:nvPr/>
        </p:nvSpPr>
        <p:spPr>
          <a:xfrm flipH="1" flipV="1">
            <a:off x="2377970" y="4970663"/>
            <a:ext cx="335" cy="1276519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108" name="Group 108"/>
          <p:cNvGrpSpPr/>
          <p:nvPr/>
        </p:nvGrpSpPr>
        <p:grpSpPr>
          <a:xfrm>
            <a:off x="2344212" y="6192359"/>
            <a:ext cx="67516" cy="67516"/>
            <a:chOff x="0" y="0"/>
            <a:chExt cx="812800" cy="812800"/>
          </a:xfrm>
        </p:grpSpPr>
        <p:sp>
          <p:nvSpPr>
            <p:cNvPr id="109" name="Freeform 109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10" name="TextBox 110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11" name="AutoShape 111"/>
          <p:cNvSpPr/>
          <p:nvPr/>
        </p:nvSpPr>
        <p:spPr>
          <a:xfrm flipV="1">
            <a:off x="2541794" y="4477171"/>
            <a:ext cx="0" cy="456697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112" name="Group 112"/>
          <p:cNvGrpSpPr/>
          <p:nvPr/>
        </p:nvGrpSpPr>
        <p:grpSpPr>
          <a:xfrm>
            <a:off x="2508036" y="4443413"/>
            <a:ext cx="67516" cy="67516"/>
            <a:chOff x="0" y="0"/>
            <a:chExt cx="812800" cy="812800"/>
          </a:xfrm>
        </p:grpSpPr>
        <p:sp>
          <p:nvSpPr>
            <p:cNvPr id="113" name="Freeform 113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14" name="TextBox 114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15" name="AutoShape 115"/>
          <p:cNvSpPr/>
          <p:nvPr/>
        </p:nvSpPr>
        <p:spPr>
          <a:xfrm flipV="1">
            <a:off x="2745219" y="5090726"/>
            <a:ext cx="2954" cy="561008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116" name="Group 116"/>
          <p:cNvGrpSpPr/>
          <p:nvPr/>
        </p:nvGrpSpPr>
        <p:grpSpPr>
          <a:xfrm>
            <a:off x="2714415" y="5634821"/>
            <a:ext cx="67516" cy="67516"/>
            <a:chOff x="0" y="0"/>
            <a:chExt cx="812800" cy="812800"/>
          </a:xfrm>
        </p:grpSpPr>
        <p:sp>
          <p:nvSpPr>
            <p:cNvPr id="117" name="Freeform 117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18" name="TextBox 118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19" name="AutoShape 119"/>
          <p:cNvSpPr/>
          <p:nvPr/>
        </p:nvSpPr>
        <p:spPr>
          <a:xfrm flipV="1">
            <a:off x="3215023" y="4495042"/>
            <a:ext cx="0" cy="637540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120" name="Group 120"/>
          <p:cNvGrpSpPr/>
          <p:nvPr/>
        </p:nvGrpSpPr>
        <p:grpSpPr>
          <a:xfrm>
            <a:off x="3181265" y="4461285"/>
            <a:ext cx="67516" cy="67516"/>
            <a:chOff x="0" y="0"/>
            <a:chExt cx="812800" cy="812800"/>
          </a:xfrm>
        </p:grpSpPr>
        <p:sp>
          <p:nvSpPr>
            <p:cNvPr id="121" name="Freeform 121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22" name="TextBox 122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23" name="AutoShape 123"/>
          <p:cNvSpPr/>
          <p:nvPr/>
        </p:nvSpPr>
        <p:spPr>
          <a:xfrm flipH="1" flipV="1">
            <a:off x="3304089" y="5265959"/>
            <a:ext cx="4762" cy="859773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124" name="Group 124"/>
          <p:cNvGrpSpPr/>
          <p:nvPr/>
        </p:nvGrpSpPr>
        <p:grpSpPr>
          <a:xfrm>
            <a:off x="3275094" y="6108044"/>
            <a:ext cx="67516" cy="67516"/>
            <a:chOff x="0" y="0"/>
            <a:chExt cx="812800" cy="812800"/>
          </a:xfrm>
        </p:grpSpPr>
        <p:sp>
          <p:nvSpPr>
            <p:cNvPr id="125" name="Freeform 125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26" name="TextBox 126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27" name="AutoShape 127"/>
          <p:cNvSpPr/>
          <p:nvPr/>
        </p:nvSpPr>
        <p:spPr>
          <a:xfrm flipH="1" flipV="1">
            <a:off x="3685463" y="5275458"/>
            <a:ext cx="3069" cy="384136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128" name="Group 128"/>
          <p:cNvGrpSpPr/>
          <p:nvPr/>
        </p:nvGrpSpPr>
        <p:grpSpPr>
          <a:xfrm>
            <a:off x="3651705" y="5592078"/>
            <a:ext cx="67516" cy="67516"/>
            <a:chOff x="0" y="0"/>
            <a:chExt cx="812800" cy="812800"/>
          </a:xfrm>
        </p:grpSpPr>
        <p:sp>
          <p:nvSpPr>
            <p:cNvPr id="129" name="Freeform 129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30" name="TextBox 130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31" name="AutoShape 131"/>
          <p:cNvSpPr/>
          <p:nvPr/>
        </p:nvSpPr>
        <p:spPr>
          <a:xfrm flipH="1" flipV="1">
            <a:off x="4291787" y="5356947"/>
            <a:ext cx="3069" cy="384136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132" name="Group 132"/>
          <p:cNvGrpSpPr/>
          <p:nvPr/>
        </p:nvGrpSpPr>
        <p:grpSpPr>
          <a:xfrm>
            <a:off x="4258029" y="5676769"/>
            <a:ext cx="67516" cy="67516"/>
            <a:chOff x="0" y="0"/>
            <a:chExt cx="812800" cy="812800"/>
          </a:xfrm>
        </p:grpSpPr>
        <p:sp>
          <p:nvSpPr>
            <p:cNvPr id="133" name="Freeform 133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34" name="TextBox 134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35" name="AutoShape 135"/>
          <p:cNvSpPr/>
          <p:nvPr/>
        </p:nvSpPr>
        <p:spPr>
          <a:xfrm flipV="1">
            <a:off x="5463973" y="5391332"/>
            <a:ext cx="5526" cy="834753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136" name="Group 136"/>
          <p:cNvGrpSpPr/>
          <p:nvPr/>
        </p:nvGrpSpPr>
        <p:grpSpPr>
          <a:xfrm>
            <a:off x="5427206" y="6152759"/>
            <a:ext cx="73326" cy="73326"/>
            <a:chOff x="0" y="0"/>
            <a:chExt cx="812800" cy="812800"/>
          </a:xfrm>
        </p:grpSpPr>
        <p:sp>
          <p:nvSpPr>
            <p:cNvPr id="137" name="Freeform 137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38" name="TextBox 138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39" name="AutoShape 139"/>
          <p:cNvSpPr/>
          <p:nvPr/>
        </p:nvSpPr>
        <p:spPr>
          <a:xfrm flipH="1" flipV="1">
            <a:off x="4293176" y="4211420"/>
            <a:ext cx="3069" cy="384136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140" name="Group 140"/>
          <p:cNvGrpSpPr/>
          <p:nvPr/>
        </p:nvGrpSpPr>
        <p:grpSpPr>
          <a:xfrm>
            <a:off x="4262488" y="4540825"/>
            <a:ext cx="67516" cy="67516"/>
            <a:chOff x="0" y="0"/>
            <a:chExt cx="812800" cy="812800"/>
          </a:xfrm>
        </p:grpSpPr>
        <p:sp>
          <p:nvSpPr>
            <p:cNvPr id="141" name="Freeform 141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42" name="TextBox 142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grpSp>
        <p:nvGrpSpPr>
          <p:cNvPr id="143" name="Group 143"/>
          <p:cNvGrpSpPr/>
          <p:nvPr/>
        </p:nvGrpSpPr>
        <p:grpSpPr>
          <a:xfrm>
            <a:off x="5156973" y="2719226"/>
            <a:ext cx="67516" cy="67516"/>
            <a:chOff x="0" y="0"/>
            <a:chExt cx="812800" cy="812800"/>
          </a:xfrm>
        </p:grpSpPr>
        <p:sp>
          <p:nvSpPr>
            <p:cNvPr id="144" name="Freeform 144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45" name="TextBox 145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46" name="AutoShape 146"/>
          <p:cNvSpPr/>
          <p:nvPr/>
        </p:nvSpPr>
        <p:spPr>
          <a:xfrm flipV="1">
            <a:off x="5186130" y="2775707"/>
            <a:ext cx="4600" cy="1334980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147" name="Group 147"/>
          <p:cNvGrpSpPr/>
          <p:nvPr/>
        </p:nvGrpSpPr>
        <p:grpSpPr>
          <a:xfrm>
            <a:off x="5576607" y="2244267"/>
            <a:ext cx="77366" cy="77366"/>
            <a:chOff x="0" y="0"/>
            <a:chExt cx="812800" cy="812800"/>
          </a:xfrm>
        </p:grpSpPr>
        <p:sp>
          <p:nvSpPr>
            <p:cNvPr id="148" name="Freeform 148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49" name="TextBox 149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50" name="AutoShape 150"/>
          <p:cNvSpPr/>
          <p:nvPr/>
        </p:nvSpPr>
        <p:spPr>
          <a:xfrm flipH="1" flipV="1">
            <a:off x="5610528" y="2256912"/>
            <a:ext cx="0" cy="1679108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sp>
        <p:nvSpPr>
          <p:cNvPr id="151" name="AutoShape 151"/>
          <p:cNvSpPr/>
          <p:nvPr/>
        </p:nvSpPr>
        <p:spPr>
          <a:xfrm flipV="1">
            <a:off x="5316960" y="4510929"/>
            <a:ext cx="0" cy="637540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152" name="Group 152"/>
          <p:cNvGrpSpPr/>
          <p:nvPr/>
        </p:nvGrpSpPr>
        <p:grpSpPr>
          <a:xfrm>
            <a:off x="5283203" y="5098390"/>
            <a:ext cx="67516" cy="67516"/>
            <a:chOff x="0" y="0"/>
            <a:chExt cx="812800" cy="812800"/>
          </a:xfrm>
        </p:grpSpPr>
        <p:sp>
          <p:nvSpPr>
            <p:cNvPr id="153" name="Freeform 153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54" name="TextBox 154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55" name="AutoShape 155"/>
          <p:cNvSpPr/>
          <p:nvPr/>
        </p:nvSpPr>
        <p:spPr>
          <a:xfrm flipV="1">
            <a:off x="5687731" y="4443413"/>
            <a:ext cx="0" cy="637540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156" name="Group 156"/>
          <p:cNvGrpSpPr/>
          <p:nvPr/>
        </p:nvGrpSpPr>
        <p:grpSpPr>
          <a:xfrm>
            <a:off x="5653973" y="5047195"/>
            <a:ext cx="67516" cy="67516"/>
            <a:chOff x="0" y="0"/>
            <a:chExt cx="812800" cy="812800"/>
          </a:xfrm>
        </p:grpSpPr>
        <p:sp>
          <p:nvSpPr>
            <p:cNvPr id="157" name="Freeform 157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58" name="TextBox 158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grpSp>
        <p:nvGrpSpPr>
          <p:cNvPr id="159" name="Group 159"/>
          <p:cNvGrpSpPr/>
          <p:nvPr/>
        </p:nvGrpSpPr>
        <p:grpSpPr>
          <a:xfrm>
            <a:off x="7048285" y="2028864"/>
            <a:ext cx="71495" cy="71495"/>
            <a:chOff x="0" y="0"/>
            <a:chExt cx="812800" cy="812800"/>
          </a:xfrm>
        </p:grpSpPr>
        <p:sp>
          <p:nvSpPr>
            <p:cNvPr id="160" name="Freeform 160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61" name="TextBox 161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62" name="AutoShape 162"/>
          <p:cNvSpPr/>
          <p:nvPr/>
        </p:nvSpPr>
        <p:spPr>
          <a:xfrm flipH="1" flipV="1">
            <a:off x="7084033" y="2105457"/>
            <a:ext cx="4524" cy="1262739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163" name="Group 163"/>
          <p:cNvGrpSpPr/>
          <p:nvPr/>
        </p:nvGrpSpPr>
        <p:grpSpPr>
          <a:xfrm>
            <a:off x="7754364" y="2747699"/>
            <a:ext cx="78086" cy="78086"/>
            <a:chOff x="0" y="0"/>
            <a:chExt cx="812800" cy="812800"/>
          </a:xfrm>
        </p:grpSpPr>
        <p:sp>
          <p:nvSpPr>
            <p:cNvPr id="164" name="Freeform 164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65" name="TextBox 165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66" name="AutoShape 166"/>
          <p:cNvSpPr/>
          <p:nvPr/>
        </p:nvSpPr>
        <p:spPr>
          <a:xfrm flipH="1" flipV="1">
            <a:off x="7093320" y="4269217"/>
            <a:ext cx="3069" cy="384136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167" name="Group 167"/>
          <p:cNvGrpSpPr/>
          <p:nvPr/>
        </p:nvGrpSpPr>
        <p:grpSpPr>
          <a:xfrm>
            <a:off x="7059562" y="4624400"/>
            <a:ext cx="67516" cy="67516"/>
            <a:chOff x="0" y="0"/>
            <a:chExt cx="812800" cy="812800"/>
          </a:xfrm>
        </p:grpSpPr>
        <p:sp>
          <p:nvSpPr>
            <p:cNvPr id="168" name="Freeform 168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69" name="TextBox 169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70" name="Freeform 170"/>
          <p:cNvSpPr/>
          <p:nvPr/>
        </p:nvSpPr>
        <p:spPr>
          <a:xfrm>
            <a:off x="5823673" y="2537259"/>
            <a:ext cx="994689" cy="1089272"/>
          </a:xfrm>
          <a:custGeom>
            <a:avLst/>
            <a:gdLst/>
            <a:ahLst/>
            <a:cxnLst/>
            <a:rect l="l" t="t" r="r" b="b"/>
            <a:pathLst>
              <a:path w="994689" h="1089272">
                <a:moveTo>
                  <a:pt x="0" y="0"/>
                </a:moveTo>
                <a:lnTo>
                  <a:pt x="994689" y="0"/>
                </a:lnTo>
                <a:lnTo>
                  <a:pt x="994689" y="1089272"/>
                </a:lnTo>
                <a:lnTo>
                  <a:pt x="0" y="1089272"/>
                </a:lnTo>
                <a:lnTo>
                  <a:pt x="0" y="0"/>
                </a:lnTo>
                <a:close/>
              </a:path>
            </a:pathLst>
          </a:custGeom>
          <a:blipFill>
            <a:blip r:embed="rId3"/>
            <a:stretch>
              <a:fillRect l="-593807" t="-84692" r="-335511" b="-285670"/>
            </a:stretch>
          </a:blipFill>
        </p:spPr>
        <p:txBody>
          <a:bodyPr/>
          <a:lstStyle/>
          <a:p>
            <a:endParaRPr lang="en-US"/>
          </a:p>
        </p:txBody>
      </p:sp>
      <p:sp>
        <p:nvSpPr>
          <p:cNvPr id="171" name="AutoShape 171"/>
          <p:cNvSpPr/>
          <p:nvPr/>
        </p:nvSpPr>
        <p:spPr>
          <a:xfrm flipH="1" flipV="1">
            <a:off x="6316902" y="2206863"/>
            <a:ext cx="8232" cy="1137688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172" name="Group 172"/>
          <p:cNvGrpSpPr/>
          <p:nvPr/>
        </p:nvGrpSpPr>
        <p:grpSpPr>
          <a:xfrm>
            <a:off x="5854519" y="2947378"/>
            <a:ext cx="67516" cy="67516"/>
            <a:chOff x="0" y="0"/>
            <a:chExt cx="812800" cy="812800"/>
          </a:xfrm>
        </p:grpSpPr>
        <p:sp>
          <p:nvSpPr>
            <p:cNvPr id="173" name="Freeform 173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74" name="TextBox 174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grpSp>
        <p:nvGrpSpPr>
          <p:cNvPr id="175" name="Group 175"/>
          <p:cNvGrpSpPr/>
          <p:nvPr/>
        </p:nvGrpSpPr>
        <p:grpSpPr>
          <a:xfrm>
            <a:off x="6283144" y="2139347"/>
            <a:ext cx="67516" cy="67516"/>
            <a:chOff x="0" y="0"/>
            <a:chExt cx="812800" cy="812800"/>
          </a:xfrm>
        </p:grpSpPr>
        <p:sp>
          <p:nvSpPr>
            <p:cNvPr id="176" name="Freeform 176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177" name="TextBox 177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178" name="Freeform 178"/>
          <p:cNvSpPr/>
          <p:nvPr/>
        </p:nvSpPr>
        <p:spPr>
          <a:xfrm>
            <a:off x="7260427" y="3384944"/>
            <a:ext cx="2484027" cy="2358929"/>
          </a:xfrm>
          <a:custGeom>
            <a:avLst/>
            <a:gdLst/>
            <a:ahLst/>
            <a:cxnLst/>
            <a:rect l="l" t="t" r="r" b="b"/>
            <a:pathLst>
              <a:path w="2484027" h="2358929">
                <a:moveTo>
                  <a:pt x="0" y="0"/>
                </a:moveTo>
                <a:lnTo>
                  <a:pt x="2484028" y="0"/>
                </a:lnTo>
                <a:lnTo>
                  <a:pt x="2484028" y="2358929"/>
                </a:lnTo>
                <a:lnTo>
                  <a:pt x="0" y="2358929"/>
                </a:lnTo>
                <a:lnTo>
                  <a:pt x="0" y="0"/>
                </a:lnTo>
                <a:close/>
              </a:path>
            </a:pathLst>
          </a:custGeom>
          <a:blipFill>
            <a:blip r:embed="rId4"/>
            <a:stretch>
              <a:fillRect l="-293615" t="-74514" r="-13909" b="-40232"/>
            </a:stretch>
          </a:blipFill>
        </p:spPr>
        <p:txBody>
          <a:bodyPr/>
          <a:lstStyle/>
          <a:p>
            <a:endParaRPr lang="en-US"/>
          </a:p>
        </p:txBody>
      </p:sp>
      <p:sp>
        <p:nvSpPr>
          <p:cNvPr id="179" name="TextBox 179"/>
          <p:cNvSpPr txBox="1"/>
          <p:nvPr/>
        </p:nvSpPr>
        <p:spPr>
          <a:xfrm>
            <a:off x="254988" y="424180"/>
            <a:ext cx="9303556" cy="234488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1960"/>
              </a:lnSpc>
              <a:spcBef>
                <a:spcPct val="0"/>
              </a:spcBef>
            </a:pPr>
            <a:r>
              <a:rPr lang="en-US" sz="1400" b="1" dirty="0">
                <a:solidFill>
                  <a:srgbClr val="FFFFFF"/>
                </a:solidFill>
                <a:latin typeface="Times New Roman Bold"/>
                <a:ea typeface="Times New Roman Bold"/>
                <a:cs typeface="Times New Roman Bold"/>
                <a:sym typeface="Times New Roman Bold"/>
              </a:rPr>
              <a:t>Geographical distribution of food poisoning cases associated with Indonesia’s free school meals </a:t>
            </a:r>
            <a:r>
              <a:rPr lang="en-US" sz="1400" b="1" dirty="0" err="1">
                <a:solidFill>
                  <a:srgbClr val="FFFFFF"/>
                </a:solidFill>
                <a:latin typeface="Times New Roman Bold"/>
                <a:ea typeface="Times New Roman Bold"/>
                <a:cs typeface="Times New Roman Bold"/>
                <a:sym typeface="Times New Roman Bold"/>
              </a:rPr>
              <a:t>programme</a:t>
            </a:r>
            <a:r>
              <a:rPr lang="en-US" sz="1400" b="1" dirty="0">
                <a:solidFill>
                  <a:srgbClr val="FFFFFF"/>
                </a:solidFill>
                <a:latin typeface="Times New Roman Bold"/>
                <a:ea typeface="Times New Roman Bold"/>
                <a:cs typeface="Times New Roman Bold"/>
                <a:sym typeface="Times New Roman Bold"/>
              </a:rPr>
              <a:t>, 2025</a:t>
            </a:r>
          </a:p>
        </p:txBody>
      </p:sp>
      <p:sp>
        <p:nvSpPr>
          <p:cNvPr id="181" name="TextBox 181"/>
          <p:cNvSpPr txBox="1"/>
          <p:nvPr/>
        </p:nvSpPr>
        <p:spPr>
          <a:xfrm>
            <a:off x="809709" y="6685116"/>
            <a:ext cx="4897502" cy="34419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>
              <a:lnSpc>
                <a:spcPts val="1399"/>
              </a:lnSpc>
              <a:spcBef>
                <a:spcPct val="0"/>
              </a:spcBef>
            </a:pPr>
            <a:r>
              <a:rPr lang="en-US" sz="999" dirty="0">
                <a:solidFill>
                  <a:srgbClr val="FFFFFF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rimary Source: Primary Health </a:t>
            </a:r>
            <a:r>
              <a:rPr lang="en-US" sz="999" dirty="0" err="1">
                <a:solidFill>
                  <a:srgbClr val="FFFFFF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entres</a:t>
            </a:r>
            <a:r>
              <a:rPr lang="en-US" sz="999" dirty="0">
                <a:solidFill>
                  <a:srgbClr val="FFFFFF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Early Warning Alert and Hospitals Registry. </a:t>
            </a:r>
          </a:p>
          <a:p>
            <a:pPr>
              <a:lnSpc>
                <a:spcPts val="1399"/>
              </a:lnSpc>
              <a:spcBef>
                <a:spcPct val="0"/>
              </a:spcBef>
            </a:pPr>
            <a:r>
              <a:rPr lang="en-US" sz="999" dirty="0">
                <a:solidFill>
                  <a:srgbClr val="FFFFFF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Data as per 31 December 2025</a:t>
            </a:r>
          </a:p>
        </p:txBody>
      </p:sp>
      <p:sp>
        <p:nvSpPr>
          <p:cNvPr id="182" name="TextBox 182"/>
          <p:cNvSpPr txBox="1"/>
          <p:nvPr/>
        </p:nvSpPr>
        <p:spPr>
          <a:xfrm>
            <a:off x="90951" y="3719711"/>
            <a:ext cx="509226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Aceh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22 cases)</a:t>
            </a:r>
          </a:p>
        </p:txBody>
      </p:sp>
      <p:sp>
        <p:nvSpPr>
          <p:cNvPr id="183" name="TextBox 183"/>
          <p:cNvSpPr txBox="1"/>
          <p:nvPr/>
        </p:nvSpPr>
        <p:spPr>
          <a:xfrm>
            <a:off x="312138" y="1930623"/>
            <a:ext cx="919474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North Sumatera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119 cases)</a:t>
            </a:r>
          </a:p>
        </p:txBody>
      </p:sp>
      <p:sp>
        <p:nvSpPr>
          <p:cNvPr id="184" name="TextBox 184"/>
          <p:cNvSpPr txBox="1"/>
          <p:nvPr/>
        </p:nvSpPr>
        <p:spPr>
          <a:xfrm>
            <a:off x="4273650" y="6281461"/>
            <a:ext cx="912480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West Nusa Tenggara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380 cases)</a:t>
            </a:r>
          </a:p>
        </p:txBody>
      </p:sp>
      <p:sp>
        <p:nvSpPr>
          <p:cNvPr id="185" name="TextBox 185"/>
          <p:cNvSpPr txBox="1"/>
          <p:nvPr/>
        </p:nvSpPr>
        <p:spPr>
          <a:xfrm>
            <a:off x="1136752" y="2121341"/>
            <a:ext cx="818292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Riau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74 cases)</a:t>
            </a:r>
          </a:p>
        </p:txBody>
      </p:sp>
      <p:sp>
        <p:nvSpPr>
          <p:cNvPr id="186" name="TextBox 186"/>
          <p:cNvSpPr txBox="1"/>
          <p:nvPr/>
        </p:nvSpPr>
        <p:spPr>
          <a:xfrm>
            <a:off x="2098525" y="1945440"/>
            <a:ext cx="603223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Riau Islands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335 cases)</a:t>
            </a:r>
          </a:p>
        </p:txBody>
      </p:sp>
      <p:sp>
        <p:nvSpPr>
          <p:cNvPr id="187" name="TextBox 187"/>
          <p:cNvSpPr txBox="1"/>
          <p:nvPr/>
        </p:nvSpPr>
        <p:spPr>
          <a:xfrm>
            <a:off x="2162706" y="3416667"/>
            <a:ext cx="717636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Bangka Belitung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21 cases)</a:t>
            </a:r>
          </a:p>
        </p:txBody>
      </p:sp>
      <p:sp>
        <p:nvSpPr>
          <p:cNvPr id="188" name="TextBox 188"/>
          <p:cNvSpPr txBox="1"/>
          <p:nvPr/>
        </p:nvSpPr>
        <p:spPr>
          <a:xfrm>
            <a:off x="2880342" y="1945440"/>
            <a:ext cx="905485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West Kalimantan</a:t>
            </a: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 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108 cases)</a:t>
            </a:r>
          </a:p>
        </p:txBody>
      </p:sp>
      <p:sp>
        <p:nvSpPr>
          <p:cNvPr id="189" name="TextBox 189"/>
          <p:cNvSpPr txBox="1"/>
          <p:nvPr/>
        </p:nvSpPr>
        <p:spPr>
          <a:xfrm>
            <a:off x="3418962" y="2557924"/>
            <a:ext cx="885808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Central Kalimantan</a:t>
            </a: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 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32 cases)</a:t>
            </a:r>
          </a:p>
        </p:txBody>
      </p:sp>
      <p:sp>
        <p:nvSpPr>
          <p:cNvPr id="190" name="TextBox 190"/>
          <p:cNvSpPr txBox="1"/>
          <p:nvPr/>
        </p:nvSpPr>
        <p:spPr>
          <a:xfrm>
            <a:off x="4109862" y="1954965"/>
            <a:ext cx="866338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North Kalimantan</a:t>
            </a: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 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148 cases)</a:t>
            </a:r>
          </a:p>
        </p:txBody>
      </p:sp>
      <p:sp>
        <p:nvSpPr>
          <p:cNvPr id="191" name="TextBox 191"/>
          <p:cNvSpPr txBox="1"/>
          <p:nvPr/>
        </p:nvSpPr>
        <p:spPr>
          <a:xfrm>
            <a:off x="26329" y="4326550"/>
            <a:ext cx="818292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West Sumatera</a:t>
            </a:r>
          </a:p>
          <a:p>
            <a:pPr algn="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154 cases)</a:t>
            </a:r>
          </a:p>
        </p:txBody>
      </p:sp>
      <p:sp>
        <p:nvSpPr>
          <p:cNvPr id="192" name="TextBox 192"/>
          <p:cNvSpPr txBox="1"/>
          <p:nvPr/>
        </p:nvSpPr>
        <p:spPr>
          <a:xfrm>
            <a:off x="600177" y="4806458"/>
            <a:ext cx="951842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Bengkulu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556 cases)</a:t>
            </a:r>
          </a:p>
        </p:txBody>
      </p:sp>
      <p:sp>
        <p:nvSpPr>
          <p:cNvPr id="193" name="TextBox 193"/>
          <p:cNvSpPr txBox="1"/>
          <p:nvPr/>
        </p:nvSpPr>
        <p:spPr>
          <a:xfrm>
            <a:off x="571793" y="5396519"/>
            <a:ext cx="818292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South Sumatera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385 cases)</a:t>
            </a:r>
          </a:p>
        </p:txBody>
      </p:sp>
      <p:sp>
        <p:nvSpPr>
          <p:cNvPr id="194" name="TextBox 194"/>
          <p:cNvSpPr txBox="1"/>
          <p:nvPr/>
        </p:nvSpPr>
        <p:spPr>
          <a:xfrm>
            <a:off x="1297561" y="5646888"/>
            <a:ext cx="818292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Lampung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480 cases)</a:t>
            </a:r>
          </a:p>
        </p:txBody>
      </p:sp>
      <p:sp>
        <p:nvSpPr>
          <p:cNvPr id="195" name="TextBox 195"/>
          <p:cNvSpPr txBox="1"/>
          <p:nvPr/>
        </p:nvSpPr>
        <p:spPr>
          <a:xfrm>
            <a:off x="1373281" y="6164631"/>
            <a:ext cx="916601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Banten</a:t>
            </a:r>
          </a:p>
          <a:p>
            <a:pPr algn="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383 cases)</a:t>
            </a:r>
          </a:p>
        </p:txBody>
      </p:sp>
      <p:sp>
        <p:nvSpPr>
          <p:cNvPr id="196" name="TextBox 196"/>
          <p:cNvSpPr txBox="1"/>
          <p:nvPr/>
        </p:nvSpPr>
        <p:spPr>
          <a:xfrm>
            <a:off x="2613232" y="4429125"/>
            <a:ext cx="507583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DKI Jakarta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151 cases)</a:t>
            </a:r>
          </a:p>
        </p:txBody>
      </p:sp>
      <p:sp>
        <p:nvSpPr>
          <p:cNvPr id="197" name="TextBox 197"/>
          <p:cNvSpPr txBox="1"/>
          <p:nvPr/>
        </p:nvSpPr>
        <p:spPr>
          <a:xfrm>
            <a:off x="2416825" y="5749962"/>
            <a:ext cx="705518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West Java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6113 cases)</a:t>
            </a:r>
          </a:p>
        </p:txBody>
      </p:sp>
      <p:sp>
        <p:nvSpPr>
          <p:cNvPr id="198" name="TextBox 198"/>
          <p:cNvSpPr txBox="1"/>
          <p:nvPr/>
        </p:nvSpPr>
        <p:spPr>
          <a:xfrm>
            <a:off x="3277356" y="4451760"/>
            <a:ext cx="547918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Central Java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3236 cases)</a:t>
            </a:r>
          </a:p>
        </p:txBody>
      </p:sp>
      <p:sp>
        <p:nvSpPr>
          <p:cNvPr id="199" name="TextBox 199"/>
          <p:cNvSpPr txBox="1"/>
          <p:nvPr/>
        </p:nvSpPr>
        <p:spPr>
          <a:xfrm>
            <a:off x="2829050" y="6212426"/>
            <a:ext cx="938914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DI Yogyakarta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2503 cases)</a:t>
            </a:r>
          </a:p>
        </p:txBody>
      </p:sp>
      <p:sp>
        <p:nvSpPr>
          <p:cNvPr id="200" name="TextBox 200"/>
          <p:cNvSpPr txBox="1"/>
          <p:nvPr/>
        </p:nvSpPr>
        <p:spPr>
          <a:xfrm>
            <a:off x="3380289" y="5714384"/>
            <a:ext cx="626011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East Java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1896 cases)</a:t>
            </a:r>
          </a:p>
        </p:txBody>
      </p:sp>
      <p:sp>
        <p:nvSpPr>
          <p:cNvPr id="201" name="TextBox 201"/>
          <p:cNvSpPr txBox="1"/>
          <p:nvPr/>
        </p:nvSpPr>
        <p:spPr>
          <a:xfrm>
            <a:off x="4062229" y="5794448"/>
            <a:ext cx="441893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Bali</a:t>
            </a:r>
          </a:p>
          <a:p>
            <a:pPr algn="l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56 cases)</a:t>
            </a:r>
          </a:p>
        </p:txBody>
      </p:sp>
      <p:sp>
        <p:nvSpPr>
          <p:cNvPr id="202" name="TextBox 202"/>
          <p:cNvSpPr txBox="1"/>
          <p:nvPr/>
        </p:nvSpPr>
        <p:spPr>
          <a:xfrm>
            <a:off x="5405205" y="6262411"/>
            <a:ext cx="911937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East Nusa Tenggara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1146 cases)</a:t>
            </a:r>
          </a:p>
        </p:txBody>
      </p:sp>
      <p:sp>
        <p:nvSpPr>
          <p:cNvPr id="203" name="TextBox 203"/>
          <p:cNvSpPr txBox="1"/>
          <p:nvPr/>
        </p:nvSpPr>
        <p:spPr>
          <a:xfrm>
            <a:off x="3917232" y="4648633"/>
            <a:ext cx="885808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South Kalimantan</a:t>
            </a: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 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170 cases)</a:t>
            </a:r>
          </a:p>
        </p:txBody>
      </p:sp>
      <p:sp>
        <p:nvSpPr>
          <p:cNvPr id="204" name="TextBox 204"/>
          <p:cNvSpPr txBox="1"/>
          <p:nvPr/>
        </p:nvSpPr>
        <p:spPr>
          <a:xfrm>
            <a:off x="4852261" y="2340958"/>
            <a:ext cx="667739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West Sulawesi</a:t>
            </a: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 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52 cases)</a:t>
            </a:r>
          </a:p>
        </p:txBody>
      </p:sp>
      <p:sp>
        <p:nvSpPr>
          <p:cNvPr id="205" name="TextBox 205"/>
          <p:cNvSpPr txBox="1"/>
          <p:nvPr/>
        </p:nvSpPr>
        <p:spPr>
          <a:xfrm>
            <a:off x="5259601" y="1959631"/>
            <a:ext cx="895219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Central Sulawesi</a:t>
            </a: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 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546 cases)</a:t>
            </a:r>
          </a:p>
        </p:txBody>
      </p:sp>
      <p:sp>
        <p:nvSpPr>
          <p:cNvPr id="206" name="TextBox 206"/>
          <p:cNvSpPr txBox="1"/>
          <p:nvPr/>
        </p:nvSpPr>
        <p:spPr>
          <a:xfrm>
            <a:off x="5707210" y="2628527"/>
            <a:ext cx="563537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l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Gorontalo</a:t>
            </a: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 </a:t>
            </a:r>
          </a:p>
          <a:p>
            <a:pPr algn="l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16 cases)</a:t>
            </a:r>
          </a:p>
        </p:txBody>
      </p:sp>
      <p:sp>
        <p:nvSpPr>
          <p:cNvPr id="207" name="TextBox 207"/>
          <p:cNvSpPr txBox="1"/>
          <p:nvPr/>
        </p:nvSpPr>
        <p:spPr>
          <a:xfrm>
            <a:off x="4393657" y="4940260"/>
            <a:ext cx="856182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South Sulawesi</a:t>
            </a: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 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101 cases)</a:t>
            </a:r>
          </a:p>
        </p:txBody>
      </p:sp>
      <p:sp>
        <p:nvSpPr>
          <p:cNvPr id="208" name="TextBox 208"/>
          <p:cNvSpPr txBox="1"/>
          <p:nvPr/>
        </p:nvSpPr>
        <p:spPr>
          <a:xfrm>
            <a:off x="5759589" y="4903331"/>
            <a:ext cx="930822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l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Southeast Sulawesi</a:t>
            </a: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 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263 cases)</a:t>
            </a:r>
          </a:p>
        </p:txBody>
      </p:sp>
      <p:sp>
        <p:nvSpPr>
          <p:cNvPr id="209" name="TextBox 209"/>
          <p:cNvSpPr txBox="1"/>
          <p:nvPr/>
        </p:nvSpPr>
        <p:spPr>
          <a:xfrm>
            <a:off x="7156844" y="1959631"/>
            <a:ext cx="631419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l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North Maluku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138 cases)</a:t>
            </a:r>
          </a:p>
        </p:txBody>
      </p:sp>
      <p:sp>
        <p:nvSpPr>
          <p:cNvPr id="210" name="TextBox 210"/>
          <p:cNvSpPr txBox="1"/>
          <p:nvPr/>
        </p:nvSpPr>
        <p:spPr>
          <a:xfrm>
            <a:off x="7865867" y="2958155"/>
            <a:ext cx="818292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West Papua</a:t>
            </a: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 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52 cases)</a:t>
            </a:r>
          </a:p>
        </p:txBody>
      </p:sp>
      <p:sp>
        <p:nvSpPr>
          <p:cNvPr id="211" name="TextBox 211"/>
          <p:cNvSpPr txBox="1"/>
          <p:nvPr/>
        </p:nvSpPr>
        <p:spPr>
          <a:xfrm>
            <a:off x="6747561" y="4733599"/>
            <a:ext cx="681296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Maluku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418 cases)</a:t>
            </a:r>
          </a:p>
        </p:txBody>
      </p:sp>
      <p:sp>
        <p:nvSpPr>
          <p:cNvPr id="212" name="TextBox 212"/>
          <p:cNvSpPr txBox="1"/>
          <p:nvPr/>
        </p:nvSpPr>
        <p:spPr>
          <a:xfrm>
            <a:off x="6266188" y="1959631"/>
            <a:ext cx="670730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North Sulawesi</a:t>
            </a: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 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52 cases)</a:t>
            </a:r>
          </a:p>
        </p:txBody>
      </p:sp>
      <p:sp>
        <p:nvSpPr>
          <p:cNvPr id="213" name="AutoShape 213"/>
          <p:cNvSpPr/>
          <p:nvPr/>
        </p:nvSpPr>
        <p:spPr>
          <a:xfrm flipH="1" flipV="1">
            <a:off x="9022080" y="2256912"/>
            <a:ext cx="9287" cy="1898299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sp>
        <p:nvSpPr>
          <p:cNvPr id="214" name="AutoShape 214"/>
          <p:cNvSpPr/>
          <p:nvPr/>
        </p:nvSpPr>
        <p:spPr>
          <a:xfrm flipH="1" flipV="1">
            <a:off x="7793407" y="2753018"/>
            <a:ext cx="8232" cy="1137688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sp>
        <p:nvSpPr>
          <p:cNvPr id="215" name="TextBox 215"/>
          <p:cNvSpPr txBox="1"/>
          <p:nvPr/>
        </p:nvSpPr>
        <p:spPr>
          <a:xfrm>
            <a:off x="7359020" y="2460214"/>
            <a:ext cx="818292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Southwest Papua</a:t>
            </a: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 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86 cases)</a:t>
            </a:r>
          </a:p>
        </p:txBody>
      </p:sp>
      <p:grpSp>
        <p:nvGrpSpPr>
          <p:cNvPr id="216" name="Group 216"/>
          <p:cNvGrpSpPr/>
          <p:nvPr/>
        </p:nvGrpSpPr>
        <p:grpSpPr>
          <a:xfrm>
            <a:off x="8225501" y="3240241"/>
            <a:ext cx="78086" cy="78086"/>
            <a:chOff x="0" y="0"/>
            <a:chExt cx="812800" cy="812800"/>
          </a:xfrm>
        </p:grpSpPr>
        <p:sp>
          <p:nvSpPr>
            <p:cNvPr id="217" name="Freeform 217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218" name="TextBox 218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219" name="AutoShape 219"/>
          <p:cNvSpPr/>
          <p:nvPr/>
        </p:nvSpPr>
        <p:spPr>
          <a:xfrm flipV="1">
            <a:off x="8258839" y="3299277"/>
            <a:ext cx="0" cy="999220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220" name="Group 220"/>
          <p:cNvGrpSpPr/>
          <p:nvPr/>
        </p:nvGrpSpPr>
        <p:grpSpPr>
          <a:xfrm>
            <a:off x="8983037" y="2234183"/>
            <a:ext cx="78086" cy="78086"/>
            <a:chOff x="0" y="0"/>
            <a:chExt cx="812800" cy="812800"/>
          </a:xfrm>
        </p:grpSpPr>
        <p:sp>
          <p:nvSpPr>
            <p:cNvPr id="221" name="Freeform 221"/>
            <p:cNvSpPr/>
            <p:nvPr/>
          </p:nvSpPr>
          <p:spPr>
            <a:xfrm>
              <a:off x="0" y="0"/>
              <a:ext cx="812800" cy="812800"/>
            </a:xfrm>
            <a:custGeom>
              <a:avLst/>
              <a:gdLst/>
              <a:ahLst/>
              <a:cxnLst/>
              <a:rect l="l" t="t" r="r" b="b"/>
              <a:pathLst>
                <a:path w="812800" h="812800">
                  <a:moveTo>
                    <a:pt x="406400" y="0"/>
                  </a:moveTo>
                  <a:cubicBezTo>
                    <a:pt x="181951" y="0"/>
                    <a:pt x="0" y="181951"/>
                    <a:pt x="0" y="406400"/>
                  </a:cubicBezTo>
                  <a:cubicBezTo>
                    <a:pt x="0" y="630849"/>
                    <a:pt x="181951" y="812800"/>
                    <a:pt x="406400" y="812800"/>
                  </a:cubicBezTo>
                  <a:cubicBezTo>
                    <a:pt x="630849" y="812800"/>
                    <a:pt x="812800" y="630849"/>
                    <a:pt x="812800" y="406400"/>
                  </a:cubicBezTo>
                  <a:cubicBezTo>
                    <a:pt x="812800" y="181951"/>
                    <a:pt x="630849" y="0"/>
                    <a:pt x="406400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222" name="TextBox 222"/>
            <p:cNvSpPr txBox="1"/>
            <p:nvPr/>
          </p:nvSpPr>
          <p:spPr>
            <a:xfrm>
              <a:off x="76200" y="76200"/>
              <a:ext cx="660400" cy="660400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39"/>
                </a:lnSpc>
              </a:pPr>
              <a:endParaRPr/>
            </a:p>
          </p:txBody>
        </p:sp>
      </p:grpSp>
      <p:sp>
        <p:nvSpPr>
          <p:cNvPr id="223" name="TextBox 223"/>
          <p:cNvSpPr txBox="1"/>
          <p:nvPr/>
        </p:nvSpPr>
        <p:spPr>
          <a:xfrm>
            <a:off x="8573891" y="1954965"/>
            <a:ext cx="818292" cy="228817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980"/>
              </a:lnSpc>
            </a:pPr>
            <a:r>
              <a:rPr lang="en-US" sz="700" b="1">
                <a:solidFill>
                  <a:srgbClr val="FFFFFF"/>
                </a:solidFill>
                <a:latin typeface="Canva Sans Bold"/>
                <a:ea typeface="Canva Sans Bold"/>
                <a:cs typeface="Canva Sans Bold"/>
                <a:sym typeface="Canva Sans Bold"/>
              </a:rPr>
              <a:t>Papua</a:t>
            </a: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 </a:t>
            </a:r>
          </a:p>
          <a:p>
            <a:pPr algn="ctr">
              <a:lnSpc>
                <a:spcPts val="980"/>
              </a:lnSpc>
              <a:spcBef>
                <a:spcPct val="0"/>
              </a:spcBef>
            </a:pPr>
            <a:r>
              <a:rPr lang="en-US" sz="700">
                <a:solidFill>
                  <a:srgbClr val="FFFFFF"/>
                </a:solidFill>
                <a:latin typeface="Canva Sans"/>
                <a:ea typeface="Canva Sans"/>
                <a:cs typeface="Canva Sans"/>
                <a:sym typeface="Canva Sans"/>
              </a:rPr>
              <a:t>(39 cases)</a:t>
            </a:r>
          </a:p>
        </p:txBody>
      </p:sp>
      <p:grpSp>
        <p:nvGrpSpPr>
          <p:cNvPr id="224" name="Group 224"/>
          <p:cNvGrpSpPr/>
          <p:nvPr/>
        </p:nvGrpSpPr>
        <p:grpSpPr>
          <a:xfrm>
            <a:off x="1468637" y="1407405"/>
            <a:ext cx="658737" cy="249552"/>
            <a:chOff x="0" y="0"/>
            <a:chExt cx="243977" cy="92427"/>
          </a:xfrm>
        </p:grpSpPr>
        <p:sp>
          <p:nvSpPr>
            <p:cNvPr id="225" name="Freeform 225"/>
            <p:cNvSpPr/>
            <p:nvPr/>
          </p:nvSpPr>
          <p:spPr>
            <a:xfrm>
              <a:off x="0" y="0"/>
              <a:ext cx="243977" cy="92427"/>
            </a:xfrm>
            <a:custGeom>
              <a:avLst/>
              <a:gdLst/>
              <a:ahLst/>
              <a:cxnLst/>
              <a:rect l="l" t="t" r="r" b="b"/>
              <a:pathLst>
                <a:path w="243977" h="92427">
                  <a:moveTo>
                    <a:pt x="46213" y="0"/>
                  </a:moveTo>
                  <a:lnTo>
                    <a:pt x="197764" y="0"/>
                  </a:lnTo>
                  <a:cubicBezTo>
                    <a:pt x="223286" y="0"/>
                    <a:pt x="243977" y="20690"/>
                    <a:pt x="243977" y="46213"/>
                  </a:cubicBezTo>
                  <a:lnTo>
                    <a:pt x="243977" y="46213"/>
                  </a:lnTo>
                  <a:cubicBezTo>
                    <a:pt x="243977" y="58470"/>
                    <a:pt x="239108" y="70224"/>
                    <a:pt x="230441" y="78891"/>
                  </a:cubicBezTo>
                  <a:cubicBezTo>
                    <a:pt x="221775" y="87558"/>
                    <a:pt x="210020" y="92427"/>
                    <a:pt x="197764" y="92427"/>
                  </a:cubicBezTo>
                  <a:lnTo>
                    <a:pt x="46213" y="92427"/>
                  </a:lnTo>
                  <a:cubicBezTo>
                    <a:pt x="33957" y="92427"/>
                    <a:pt x="22202" y="87558"/>
                    <a:pt x="13536" y="78891"/>
                  </a:cubicBezTo>
                  <a:cubicBezTo>
                    <a:pt x="4869" y="70224"/>
                    <a:pt x="0" y="58470"/>
                    <a:pt x="0" y="46213"/>
                  </a:cubicBezTo>
                  <a:lnTo>
                    <a:pt x="0" y="46213"/>
                  </a:lnTo>
                  <a:cubicBezTo>
                    <a:pt x="0" y="33957"/>
                    <a:pt x="4869" y="22202"/>
                    <a:pt x="13536" y="13536"/>
                  </a:cubicBezTo>
                  <a:cubicBezTo>
                    <a:pt x="22202" y="4869"/>
                    <a:pt x="33957" y="0"/>
                    <a:pt x="46213" y="0"/>
                  </a:cubicBez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  <p:sp>
          <p:nvSpPr>
            <p:cNvPr id="226" name="TextBox 226"/>
            <p:cNvSpPr txBox="1"/>
            <p:nvPr/>
          </p:nvSpPr>
          <p:spPr>
            <a:xfrm>
              <a:off x="0" y="-28575"/>
              <a:ext cx="243977" cy="121002"/>
            </a:xfrm>
            <a:prstGeom prst="rect">
              <a:avLst/>
            </a:prstGeom>
          </p:spPr>
          <p:txBody>
            <a:bodyPr lIns="50800" tIns="50800" rIns="50800" bIns="50800" rtlCol="0" anchor="ctr"/>
            <a:lstStyle/>
            <a:p>
              <a:pPr algn="ctr">
                <a:lnSpc>
                  <a:spcPts val="1260"/>
                </a:lnSpc>
              </a:pPr>
              <a:r>
                <a:rPr lang="en-US" sz="900" b="1">
                  <a:solidFill>
                    <a:srgbClr val="000000"/>
                  </a:solidFill>
                  <a:latin typeface="Times New Roman Bold"/>
                  <a:ea typeface="Times New Roman Bold"/>
                  <a:cs typeface="Times New Roman Bold"/>
                  <a:sym typeface="Times New Roman Bold"/>
                </a:rPr>
                <a:t>CASES</a:t>
              </a:r>
            </a:p>
          </p:txBody>
        </p:sp>
      </p:grpSp>
      <p:sp>
        <p:nvSpPr>
          <p:cNvPr id="227" name="AutoShape 227"/>
          <p:cNvSpPr/>
          <p:nvPr/>
        </p:nvSpPr>
        <p:spPr>
          <a:xfrm flipV="1">
            <a:off x="2387830" y="2312270"/>
            <a:ext cx="0" cy="456697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sp>
        <p:nvSpPr>
          <p:cNvPr id="228" name="AutoShape 228"/>
          <p:cNvSpPr/>
          <p:nvPr/>
        </p:nvSpPr>
        <p:spPr>
          <a:xfrm flipV="1">
            <a:off x="5888277" y="3001437"/>
            <a:ext cx="0" cy="456697"/>
          </a:xfrm>
          <a:prstGeom prst="line">
            <a:avLst/>
          </a:prstGeom>
          <a:ln w="9525" cap="flat">
            <a:solidFill>
              <a:srgbClr val="EDEDED"/>
            </a:solidFill>
            <a:prstDash val="solid"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248</Words>
  <Application>Microsoft Office PowerPoint</Application>
  <PresentationFormat>Custom</PresentationFormat>
  <Paragraphs>8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Canva Sans</vt:lpstr>
      <vt:lpstr>Times New Roman Bold</vt:lpstr>
      <vt:lpstr>Arial</vt:lpstr>
      <vt:lpstr>Canva Sans Bold</vt:lpstr>
      <vt:lpstr>Times New Roman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shbone Kesehatan Mental Diagram Graph</dc:title>
  <cp:lastModifiedBy>Henry Surendra</cp:lastModifiedBy>
  <cp:revision>8</cp:revision>
  <dcterms:created xsi:type="dcterms:W3CDTF">2006-08-16T00:00:00Z</dcterms:created>
  <dcterms:modified xsi:type="dcterms:W3CDTF">2026-02-12T20:24:14Z</dcterms:modified>
  <dc:identifier>DAG47PyfyQo</dc:identifier>
</cp:coreProperties>
</file>